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  <p:sldId id="257" r:id="rId3"/>
    <p:sldId id="269" r:id="rId4"/>
    <p:sldId id="277" r:id="rId5"/>
    <p:sldId id="276" r:id="rId6"/>
    <p:sldId id="280" r:id="rId7"/>
    <p:sldId id="282" r:id="rId8"/>
    <p:sldId id="281" r:id="rId9"/>
  </p:sldIdLst>
  <p:sldSz cx="7772400" cy="100584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tsukawa, Toshihiro (NIH/NCI) [F]" initials="MT([" lastIdx="1" clrIdx="0">
    <p:extLst>
      <p:ext uri="{19B8F6BF-5375-455C-9EA6-DF929625EA0E}">
        <p15:presenceInfo xmlns:p15="http://schemas.microsoft.com/office/powerpoint/2012/main" userId="S::matsukawat2@nih.gov::55e02b82-40ad-4227-9521-e67101d9f7d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55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704D0B-9225-450E-98BE-92F42F8466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71550" y="1646133"/>
            <a:ext cx="5829300" cy="3501813"/>
          </a:xfrm>
        </p:spPr>
        <p:txBody>
          <a:bodyPr anchor="b"/>
          <a:lstStyle>
            <a:lvl1pPr algn="ctr">
              <a:defRPr sz="382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9C9617-2C5A-40C2-921B-9EE90B3A6D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1530"/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61E474-A75B-4E02-A374-1BFBC17D7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6AE7DF-886B-4AA4-BF62-055A09D30D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CCF988-CF78-4E0D-AB92-8D86A6290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545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741AA9-0B41-4A7A-80CF-2E1BEED35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7BBADF-E844-4C42-B0FE-2AFC2377A0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AECC45-B2A2-479F-8EB9-5B78028AC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302B69-57CB-495C-964F-9D2346EC3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73ED37-22ED-4D76-9BE6-3EFD14568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909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2BCA15D-0D65-471A-A700-96F0DE28D4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BCE16B-241B-4029-8F7F-44792E7ECE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FCC061-FCDA-499E-997D-726C6192A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FA55C2-7F87-4968-B348-350ED1B2F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D6D3CC-00D6-4266-A04D-3AB6ACF81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942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FFC528-6EF1-4893-BF09-179300B1A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0353C6-A171-4389-90F2-9DF14F91D4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CFBE09-62B4-43E8-86E4-0184E2833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1D510-8F5E-4BFE-B979-0955D05B7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C6D2CA-6DC6-4355-86F5-686B4401A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243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51805B-E5BF-4CE8-9AEC-62FDD6B42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0304" y="2507617"/>
            <a:ext cx="6703695" cy="4184014"/>
          </a:xfrm>
        </p:spPr>
        <p:txBody>
          <a:bodyPr anchor="b"/>
          <a:lstStyle>
            <a:lvl1pPr>
              <a:defRPr sz="382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39340F-00A3-42C3-8D7C-2F81A6874B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0304" y="6731213"/>
            <a:ext cx="6703695" cy="2200274"/>
          </a:xfrm>
        </p:spPr>
        <p:txBody>
          <a:bodyPr/>
          <a:lstStyle>
            <a:lvl1pPr marL="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1pPr>
            <a:lvl2pPr marL="291465" indent="0">
              <a:buNone/>
              <a:defRPr sz="1275">
                <a:solidFill>
                  <a:schemeClr val="tx1">
                    <a:tint val="75000"/>
                  </a:schemeClr>
                </a:solidFill>
              </a:defRPr>
            </a:lvl2pPr>
            <a:lvl3pPr marL="582930" indent="0">
              <a:buNone/>
              <a:defRPr sz="1148">
                <a:solidFill>
                  <a:schemeClr val="tx1">
                    <a:tint val="75000"/>
                  </a:schemeClr>
                </a:solidFill>
              </a:defRPr>
            </a:lvl3pPr>
            <a:lvl4pPr marL="87439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4pPr>
            <a:lvl5pPr marL="1165860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5pPr>
            <a:lvl6pPr marL="145732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6pPr>
            <a:lvl7pPr marL="1748790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7pPr>
            <a:lvl8pPr marL="204025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8pPr>
            <a:lvl9pPr marL="2331720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8B853-5493-4B11-8B53-23B46E814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853968-4F5F-4F5A-9AEB-5AF57EF26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63623B-0CBE-430A-BB72-DAF8CE30D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4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9A1D0-9C66-4B8E-AB62-C5FEDC551D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A68D5D-835F-46BC-9A5C-1CF5B1EA4A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954816-794D-4289-A240-92561F0635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CA6209-20E6-4180-9A67-B393CCEC6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1A6F08-E8CC-4537-83AC-28E069846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4E545D-71CE-4536-8887-924DE8222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871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3FCDB8-ADAD-4FD9-9B28-0147EB22B5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365" y="535517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F53587-DEFA-47B0-A914-E2C190811B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5365" y="2465706"/>
            <a:ext cx="3288089" cy="1208404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D645CA-7247-42AC-909D-F3004285CD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35365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520859-B98B-4ABF-9585-003F97E8FA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7705A0-B6EF-435C-B7DA-600AF5CC8D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5E2A815-38E0-4D76-BF0E-649D39266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536D5E-8E33-46FF-AD59-BAD37DD30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E3D27F-3F88-4E98-9222-D08071ADF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587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92C076-6299-4D6B-933B-6ED75C02EE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C194DEE-00A0-4C90-BF29-9F18B8C59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9BBD32-3620-45EB-A29A-5870A424E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41BEB7-D808-4046-8FE0-26C87F47E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841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4E4F79-44C6-4483-9910-AB24DA561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494EC1-3D43-4356-B07C-1F07BC3B4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956D5C-C171-4052-9AE9-A5EC0B104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752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D7AE8-7E7E-4DFE-888D-D39C84602B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69DFC5-7B8C-445E-A4B8-20770F6116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04282" y="1448224"/>
            <a:ext cx="3934778" cy="7147983"/>
          </a:xfrm>
        </p:spPr>
        <p:txBody>
          <a:bodyPr/>
          <a:lstStyle>
            <a:lvl1pPr>
              <a:defRPr sz="2040"/>
            </a:lvl1pPr>
            <a:lvl2pPr>
              <a:defRPr sz="1785"/>
            </a:lvl2pPr>
            <a:lvl3pPr>
              <a:defRPr sz="1530"/>
            </a:lvl3pPr>
            <a:lvl4pPr>
              <a:defRPr sz="1275"/>
            </a:lvl4pPr>
            <a:lvl5pPr>
              <a:defRPr sz="1275"/>
            </a:lvl5pPr>
            <a:lvl6pPr>
              <a:defRPr sz="1275"/>
            </a:lvl6pPr>
            <a:lvl7pPr>
              <a:defRPr sz="1275"/>
            </a:lvl7pPr>
            <a:lvl8pPr>
              <a:defRPr sz="1275"/>
            </a:lvl8pPr>
            <a:lvl9pPr>
              <a:defRPr sz="127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FC5EFE-BD10-4569-8EF9-468521411F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8911EB-E51B-455B-9F9A-4C0BFE990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B09EA6-86B2-4821-AC9E-E00B9BE1D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C66081-1182-4CF2-B078-77D5ACC00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973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3E346-FCDA-4FC9-B6E1-B04BF8EAE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EDD8C70-7AED-4D84-BB71-F00CEE03FF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304282" y="1448224"/>
            <a:ext cx="3934778" cy="7147983"/>
          </a:xfrm>
        </p:spPr>
        <p:txBody>
          <a:bodyPr/>
          <a:lstStyle>
            <a:lvl1pPr marL="0" indent="0">
              <a:buNone/>
              <a:defRPr sz="2040"/>
            </a:lvl1pPr>
            <a:lvl2pPr marL="291465" indent="0">
              <a:buNone/>
              <a:defRPr sz="1785"/>
            </a:lvl2pPr>
            <a:lvl3pPr marL="582930" indent="0">
              <a:buNone/>
              <a:defRPr sz="1530"/>
            </a:lvl3pPr>
            <a:lvl4pPr marL="874395" indent="0">
              <a:buNone/>
              <a:defRPr sz="1275"/>
            </a:lvl4pPr>
            <a:lvl5pPr marL="1165860" indent="0">
              <a:buNone/>
              <a:defRPr sz="1275"/>
            </a:lvl5pPr>
            <a:lvl6pPr marL="1457325" indent="0">
              <a:buNone/>
              <a:defRPr sz="1275"/>
            </a:lvl6pPr>
            <a:lvl7pPr marL="1748790" indent="0">
              <a:buNone/>
              <a:defRPr sz="1275"/>
            </a:lvl7pPr>
            <a:lvl8pPr marL="2040255" indent="0">
              <a:buNone/>
              <a:defRPr sz="1275"/>
            </a:lvl8pPr>
            <a:lvl9pPr marL="2331720" indent="0">
              <a:buNone/>
              <a:defRPr sz="127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DDECC2-00F6-4CA2-A83C-FC801E99F0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1740AC-43CF-437E-AC64-23AC1F8AC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071F28-7000-432A-B88C-F781ADDFF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C9E784-F77A-4556-BC12-E34BA4BBD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614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2CE0A1-31D1-4E54-ABFA-64D191341B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4353" y="535517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F7C440-1EC9-482F-A469-78C3A940F7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E29ED1-1083-45F7-82BD-9719CD77F2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34353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4B11C3-C99D-4CF8-937E-6C4A9CB8B931}" type="datetimeFigureOut">
              <a:rPr lang="en-US" smtClean="0"/>
              <a:t>4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79169F-F2A5-4713-B352-AA54751515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574608" y="9322647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E56190-7E71-47C5-A510-28BC9C638C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489258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E64FD0-5683-42E8-AA15-95662B1C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935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582930" rtl="0" eaLnBrk="1" latinLnBrk="0" hangingPunct="1">
        <a:lnSpc>
          <a:spcPct val="90000"/>
        </a:lnSpc>
        <a:spcBef>
          <a:spcPct val="0"/>
        </a:spcBef>
        <a:buNone/>
        <a:defRPr sz="28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5733" indent="-145733" algn="l" defTabSz="582930" rtl="0" eaLnBrk="1" latinLnBrk="0" hangingPunct="1">
        <a:lnSpc>
          <a:spcPct val="90000"/>
        </a:lnSpc>
        <a:spcBef>
          <a:spcPts val="638"/>
        </a:spcBef>
        <a:buFont typeface="Arial" panose="020B0604020202020204" pitchFamily="34" charset="0"/>
        <a:buChar char="•"/>
        <a:defRPr sz="1785" kern="1200">
          <a:solidFill>
            <a:schemeClr val="tx1"/>
          </a:solidFill>
          <a:latin typeface="+mn-lt"/>
          <a:ea typeface="+mn-ea"/>
          <a:cs typeface="+mn-cs"/>
        </a:defRPr>
      </a:lvl1pPr>
      <a:lvl2pPr marL="43719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2866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3pPr>
      <a:lvl4pPr marL="102012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31159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60305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89452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18598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47745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1pPr>
      <a:lvl2pPr marL="29146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2pPr>
      <a:lvl3pPr marL="58293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3pPr>
      <a:lvl4pPr marL="87439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16586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45732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74879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04025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3.emf"/><Relationship Id="rId5" Type="http://schemas.openxmlformats.org/officeDocument/2006/relationships/image" Target="../media/image8.png"/><Relationship Id="rId10" Type="http://schemas.openxmlformats.org/officeDocument/2006/relationships/oleObject" Target="../embeddings/oleObject3.bin"/><Relationship Id="rId4" Type="http://schemas.openxmlformats.org/officeDocument/2006/relationships/image" Target="../media/image7.png"/><Relationship Id="rId9" Type="http://schemas.openxmlformats.org/officeDocument/2006/relationships/image" Target="../media/image12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6">
            <a:extLst>
              <a:ext uri="{FF2B5EF4-FFF2-40B4-BE49-F238E27FC236}">
                <a16:creationId xmlns:a16="http://schemas.microsoft.com/office/drawing/2014/main" id="{6B162BEA-9410-4CAB-8AF8-71288D7BB237}"/>
              </a:ext>
            </a:extLst>
          </p:cNvPr>
          <p:cNvSpPr/>
          <p:nvPr/>
        </p:nvSpPr>
        <p:spPr>
          <a:xfrm>
            <a:off x="3000373" y="1477553"/>
            <a:ext cx="2876353" cy="176522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1FFD30E8-B6E1-4A74-AB00-80FDE7C77914}"/>
              </a:ext>
            </a:extLst>
          </p:cNvPr>
          <p:cNvSpPr/>
          <p:nvPr/>
        </p:nvSpPr>
        <p:spPr>
          <a:xfrm>
            <a:off x="3710128" y="1464354"/>
            <a:ext cx="67355" cy="199821"/>
          </a:xfrm>
          <a:prstGeom prst="ellipse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565785"/>
            <a:endParaRPr lang="en-US" sz="1114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38D1BE59-030A-4B77-90BE-AB8F156271A4}"/>
              </a:ext>
            </a:extLst>
          </p:cNvPr>
          <p:cNvSpPr/>
          <p:nvPr/>
        </p:nvSpPr>
        <p:spPr>
          <a:xfrm>
            <a:off x="3785305" y="1464354"/>
            <a:ext cx="67355" cy="199821"/>
          </a:xfrm>
          <a:prstGeom prst="ellipse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565785"/>
            <a:endParaRPr lang="en-US" sz="1114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140065FA-EDF4-46E1-B2C4-DBC3648B3FD2}"/>
              </a:ext>
            </a:extLst>
          </p:cNvPr>
          <p:cNvSpPr/>
          <p:nvPr/>
        </p:nvSpPr>
        <p:spPr>
          <a:xfrm>
            <a:off x="3859396" y="1464354"/>
            <a:ext cx="67355" cy="199821"/>
          </a:xfrm>
          <a:prstGeom prst="ellipse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565785"/>
            <a:endParaRPr lang="en-US" sz="1114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754CBD73-8D02-40F2-8420-B3EB6CCF14D3}"/>
              </a:ext>
            </a:extLst>
          </p:cNvPr>
          <p:cNvSpPr/>
          <p:nvPr/>
        </p:nvSpPr>
        <p:spPr>
          <a:xfrm>
            <a:off x="3933825" y="1464354"/>
            <a:ext cx="67355" cy="199821"/>
          </a:xfrm>
          <a:prstGeom prst="ellipse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565785"/>
            <a:endParaRPr lang="en-US" sz="1114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D9AD2D3-8B1A-4688-82E9-ABDA4AB970B8}"/>
              </a:ext>
            </a:extLst>
          </p:cNvPr>
          <p:cNvSpPr/>
          <p:nvPr/>
        </p:nvSpPr>
        <p:spPr>
          <a:xfrm>
            <a:off x="4792302" y="1477826"/>
            <a:ext cx="186353" cy="17539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565785"/>
            <a:endParaRPr lang="en-US" sz="1114" dirty="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A7E0708F-C1E2-4533-A8E0-5A81A64BFF66}"/>
              </a:ext>
            </a:extLst>
          </p:cNvPr>
          <p:cNvSpPr/>
          <p:nvPr/>
        </p:nvSpPr>
        <p:spPr>
          <a:xfrm>
            <a:off x="5148153" y="1464354"/>
            <a:ext cx="67355" cy="199821"/>
          </a:xfrm>
          <a:prstGeom prst="ellipse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565785"/>
            <a:endParaRPr lang="en-US" sz="1114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A044F04C-282B-4D39-AE27-C4E13E479D58}"/>
              </a:ext>
            </a:extLst>
          </p:cNvPr>
          <p:cNvSpPr/>
          <p:nvPr/>
        </p:nvSpPr>
        <p:spPr>
          <a:xfrm>
            <a:off x="5219946" y="1464354"/>
            <a:ext cx="55410" cy="199821"/>
          </a:xfrm>
          <a:prstGeom prst="ellips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565785"/>
            <a:endParaRPr lang="en-US" sz="1114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EAA453A-DFCD-4C37-A783-5361B44C2765}"/>
              </a:ext>
            </a:extLst>
          </p:cNvPr>
          <p:cNvSpPr txBox="1"/>
          <p:nvPr/>
        </p:nvSpPr>
        <p:spPr>
          <a:xfrm>
            <a:off x="2093486" y="937452"/>
            <a:ext cx="3680678" cy="206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65785"/>
            <a:r>
              <a:rPr lang="en-US" sz="743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P98, aa 1-518                                                Nsd1, aa 1166-2596                            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061F385-8D5D-44A7-ACF8-EB070F53F310}"/>
              </a:ext>
            </a:extLst>
          </p:cNvPr>
          <p:cNvSpPr txBox="1"/>
          <p:nvPr/>
        </p:nvSpPr>
        <p:spPr>
          <a:xfrm>
            <a:off x="3654565" y="1735386"/>
            <a:ext cx="992888" cy="206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defTabSz="565785"/>
            <a:r>
              <a:rPr lang="en-US" sz="74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D</a:t>
            </a:r>
            <a:r>
              <a:rPr lang="en-US" sz="743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-IV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14D7482-0EF6-48E9-B28F-DE89196ECA06}"/>
              </a:ext>
            </a:extLst>
          </p:cNvPr>
          <p:cNvSpPr txBox="1"/>
          <p:nvPr/>
        </p:nvSpPr>
        <p:spPr>
          <a:xfrm>
            <a:off x="3843764" y="1198497"/>
            <a:ext cx="992888" cy="206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defTabSz="565785"/>
            <a:r>
              <a:rPr lang="en-US" sz="74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WWP</a:t>
            </a:r>
            <a:endParaRPr lang="en-US" sz="743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F02DBFA-58CC-469D-AEFA-AE0E7DC6D82D}"/>
              </a:ext>
            </a:extLst>
          </p:cNvPr>
          <p:cNvSpPr txBox="1"/>
          <p:nvPr/>
        </p:nvSpPr>
        <p:spPr>
          <a:xfrm>
            <a:off x="4721237" y="1727132"/>
            <a:ext cx="992888" cy="206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defTabSz="565785"/>
            <a:r>
              <a:rPr lang="en-US" sz="74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endParaRPr lang="en-US" sz="743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2B400C5-D3A6-456E-9E0A-B3DC90C4ED16}"/>
              </a:ext>
            </a:extLst>
          </p:cNvPr>
          <p:cNvSpPr txBox="1"/>
          <p:nvPr/>
        </p:nvSpPr>
        <p:spPr>
          <a:xfrm>
            <a:off x="5016762" y="1218243"/>
            <a:ext cx="992888" cy="206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defTabSz="565785"/>
            <a:r>
              <a:rPr lang="en-US" sz="74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D</a:t>
            </a:r>
            <a:r>
              <a:rPr lang="en-US" sz="743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4241AC3-8865-4D80-BF9C-A306F4862669}"/>
              </a:ext>
            </a:extLst>
          </p:cNvPr>
          <p:cNvSpPr txBox="1"/>
          <p:nvPr/>
        </p:nvSpPr>
        <p:spPr>
          <a:xfrm>
            <a:off x="5031515" y="1735386"/>
            <a:ext cx="992888" cy="206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defTabSz="565785"/>
            <a:r>
              <a:rPr lang="en-US" sz="74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/H rich</a:t>
            </a:r>
            <a:endParaRPr lang="en-US" sz="743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7CBD1C9-3297-4D1E-9445-457360C09B90}"/>
              </a:ext>
            </a:extLst>
          </p:cNvPr>
          <p:cNvSpPr txBox="1"/>
          <p:nvPr/>
        </p:nvSpPr>
        <p:spPr>
          <a:xfrm>
            <a:off x="2108570" y="1668360"/>
            <a:ext cx="992888" cy="206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defTabSz="565785"/>
            <a:r>
              <a:rPr lang="en-US" sz="743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 FG repeats</a:t>
            </a:r>
            <a:endParaRPr lang="en-US" sz="743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Left Brace 43">
            <a:extLst>
              <a:ext uri="{FF2B5EF4-FFF2-40B4-BE49-F238E27FC236}">
                <a16:creationId xmlns:a16="http://schemas.microsoft.com/office/drawing/2014/main" id="{D06CF9A5-DFB6-405B-BCEF-F251B5EA894C}"/>
              </a:ext>
            </a:extLst>
          </p:cNvPr>
          <p:cNvSpPr/>
          <p:nvPr/>
        </p:nvSpPr>
        <p:spPr>
          <a:xfrm rot="16200000">
            <a:off x="3833801" y="1576347"/>
            <a:ext cx="37718" cy="29083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4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6A67F4A0-D051-4D94-98DA-28A2C861815B}"/>
              </a:ext>
            </a:extLst>
          </p:cNvPr>
          <p:cNvCxnSpPr>
            <a:cxnSpLocks/>
          </p:cNvCxnSpPr>
          <p:nvPr/>
        </p:nvCxnSpPr>
        <p:spPr>
          <a:xfrm>
            <a:off x="4885477" y="1682928"/>
            <a:ext cx="0" cy="8840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461D697-1BB6-4065-925F-B9D8ED8A85CF}"/>
              </a:ext>
            </a:extLst>
          </p:cNvPr>
          <p:cNvCxnSpPr>
            <a:cxnSpLocks/>
          </p:cNvCxnSpPr>
          <p:nvPr/>
        </p:nvCxnSpPr>
        <p:spPr>
          <a:xfrm>
            <a:off x="5253624" y="1679854"/>
            <a:ext cx="0" cy="8840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1DC8433F-66CE-4760-9DCD-C9284AA43CE4}"/>
              </a:ext>
            </a:extLst>
          </p:cNvPr>
          <p:cNvCxnSpPr>
            <a:cxnSpLocks/>
          </p:cNvCxnSpPr>
          <p:nvPr/>
        </p:nvCxnSpPr>
        <p:spPr>
          <a:xfrm>
            <a:off x="5181830" y="1368352"/>
            <a:ext cx="0" cy="8840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B1C4E346-051A-4D0D-A91D-635D8B20106C}"/>
              </a:ext>
            </a:extLst>
          </p:cNvPr>
          <p:cNvCxnSpPr>
            <a:cxnSpLocks/>
          </p:cNvCxnSpPr>
          <p:nvPr/>
        </p:nvCxnSpPr>
        <p:spPr>
          <a:xfrm>
            <a:off x="4068407" y="1340557"/>
            <a:ext cx="0" cy="8840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Left Bracket 48">
            <a:extLst>
              <a:ext uri="{FF2B5EF4-FFF2-40B4-BE49-F238E27FC236}">
                <a16:creationId xmlns:a16="http://schemas.microsoft.com/office/drawing/2014/main" id="{CBFE4AB5-C2E5-4057-BC4E-1C1AF00F90B3}"/>
              </a:ext>
            </a:extLst>
          </p:cNvPr>
          <p:cNvSpPr/>
          <p:nvPr/>
        </p:nvSpPr>
        <p:spPr>
          <a:xfrm rot="5400000">
            <a:off x="2467517" y="641335"/>
            <a:ext cx="37718" cy="1027994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48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Left Bracket 49">
            <a:extLst>
              <a:ext uri="{FF2B5EF4-FFF2-40B4-BE49-F238E27FC236}">
                <a16:creationId xmlns:a16="http://schemas.microsoft.com/office/drawing/2014/main" id="{B982EDB6-7A48-4466-9A50-59BCFEB99981}"/>
              </a:ext>
            </a:extLst>
          </p:cNvPr>
          <p:cNvSpPr/>
          <p:nvPr/>
        </p:nvSpPr>
        <p:spPr>
          <a:xfrm rot="5400000">
            <a:off x="4428181" y="-275038"/>
            <a:ext cx="37718" cy="2859373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48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334FF8A2-0704-4C87-B4DC-D4FC7EA2B910}"/>
              </a:ext>
            </a:extLst>
          </p:cNvPr>
          <p:cNvSpPr/>
          <p:nvPr/>
        </p:nvSpPr>
        <p:spPr>
          <a:xfrm>
            <a:off x="1983504" y="1476095"/>
            <a:ext cx="1018953" cy="178492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36F5774E-8721-473C-9106-105595F41C7C}"/>
              </a:ext>
            </a:extLst>
          </p:cNvPr>
          <p:cNvSpPr/>
          <p:nvPr/>
        </p:nvSpPr>
        <p:spPr>
          <a:xfrm>
            <a:off x="4036907" y="1473738"/>
            <a:ext cx="58957" cy="1904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65FA875E-3CDD-4F63-9CF4-96D1152B09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977508"/>
              </p:ext>
            </p:extLst>
          </p:nvPr>
        </p:nvGraphicFramePr>
        <p:xfrm>
          <a:off x="4267200" y="2116120"/>
          <a:ext cx="3265488" cy="2279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863982" imgH="2698873" progId="Prism8.Document">
                  <p:embed/>
                </p:oleObj>
              </mc:Choice>
              <mc:Fallback>
                <p:oleObj name="Prism 8" r:id="rId2" imgW="3863982" imgH="2698873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65FA875E-3CDD-4F63-9CF4-96D1152B09C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67200" y="2116120"/>
                        <a:ext cx="3265488" cy="2279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2" name="TextBox 101">
            <a:extLst>
              <a:ext uri="{FF2B5EF4-FFF2-40B4-BE49-F238E27FC236}">
                <a16:creationId xmlns:a16="http://schemas.microsoft.com/office/drawing/2014/main" id="{955F7992-CAB9-492C-8D7F-CF1194AAA07F}"/>
              </a:ext>
            </a:extLst>
          </p:cNvPr>
          <p:cNvSpPr txBox="1"/>
          <p:nvPr/>
        </p:nvSpPr>
        <p:spPr>
          <a:xfrm>
            <a:off x="489450" y="871071"/>
            <a:ext cx="3649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507775D-6DEB-4962-A13E-7BA2B26DCD6E}"/>
              </a:ext>
            </a:extLst>
          </p:cNvPr>
          <p:cNvSpPr txBox="1"/>
          <p:nvPr/>
        </p:nvSpPr>
        <p:spPr>
          <a:xfrm>
            <a:off x="559240" y="2178215"/>
            <a:ext cx="14537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337F1D5D-1C0F-46F4-B1BC-89C6C1A1C12C}"/>
              </a:ext>
            </a:extLst>
          </p:cNvPr>
          <p:cNvSpPr txBox="1"/>
          <p:nvPr/>
        </p:nvSpPr>
        <p:spPr>
          <a:xfrm>
            <a:off x="3814672" y="2110533"/>
            <a:ext cx="14537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F66780B1-C49F-4FED-ADB6-C747F8156CFB}"/>
              </a:ext>
            </a:extLst>
          </p:cNvPr>
          <p:cNvGrpSpPr/>
          <p:nvPr/>
        </p:nvGrpSpPr>
        <p:grpSpPr>
          <a:xfrm>
            <a:off x="481182" y="2539141"/>
            <a:ext cx="3323548" cy="1240665"/>
            <a:chOff x="307484" y="3371855"/>
            <a:chExt cx="3323548" cy="1240665"/>
          </a:xfrm>
        </p:grpSpPr>
        <p:pic>
          <p:nvPicPr>
            <p:cNvPr id="105" name="Picture 104" descr="A picture containing night sky&#10;&#10;Description automatically generated">
              <a:extLst>
                <a:ext uri="{FF2B5EF4-FFF2-40B4-BE49-F238E27FC236}">
                  <a16:creationId xmlns:a16="http://schemas.microsoft.com/office/drawing/2014/main" id="{087967DF-B464-4DFF-8A7A-C95CF416AE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1555963" y="3774827"/>
              <a:ext cx="1953929" cy="36518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6" name="Picture 105" descr="A picture containing kitchen appliance&#10;&#10;Description automatically generated">
              <a:extLst>
                <a:ext uri="{FF2B5EF4-FFF2-40B4-BE49-F238E27FC236}">
                  <a16:creationId xmlns:a16="http://schemas.microsoft.com/office/drawing/2014/main" id="{FDA0C067-11F3-4565-AB63-2A717EA97E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52057" y="4210343"/>
              <a:ext cx="1957052" cy="4021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08DB928-FA30-45DB-B484-EAF48F31FD25}"/>
                </a:ext>
              </a:extLst>
            </p:cNvPr>
            <p:cNvSpPr txBox="1"/>
            <p:nvPr/>
          </p:nvSpPr>
          <p:spPr>
            <a:xfrm>
              <a:off x="1519240" y="3586168"/>
              <a:ext cx="11592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BM   SP   Kid   Liv	  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4A09E758-FA6A-4FE6-98F2-41C557ADB6CE}"/>
                </a:ext>
              </a:extLst>
            </p:cNvPr>
            <p:cNvSpPr txBox="1"/>
            <p:nvPr/>
          </p:nvSpPr>
          <p:spPr>
            <a:xfrm>
              <a:off x="2471740" y="3586166"/>
              <a:ext cx="11592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BM   SP   Kid   Liv	  </a:t>
              </a: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4B7E1CB8-0623-4942-9B6F-E8237769F791}"/>
                </a:ext>
              </a:extLst>
            </p:cNvPr>
            <p:cNvCxnSpPr>
              <a:cxnSpLocks/>
            </p:cNvCxnSpPr>
            <p:nvPr/>
          </p:nvCxnSpPr>
          <p:spPr>
            <a:xfrm>
              <a:off x="1638308" y="3614720"/>
              <a:ext cx="71913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D09324AB-000D-44A9-8CF0-94B03B4C5151}"/>
                </a:ext>
              </a:extLst>
            </p:cNvPr>
            <p:cNvCxnSpPr>
              <a:cxnSpLocks/>
            </p:cNvCxnSpPr>
            <p:nvPr/>
          </p:nvCxnSpPr>
          <p:spPr>
            <a:xfrm>
              <a:off x="2576520" y="3614721"/>
              <a:ext cx="71913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6CA93BD-7298-45DD-9BF8-E6E4AFF1B909}"/>
                </a:ext>
              </a:extLst>
            </p:cNvPr>
            <p:cNvSpPr txBox="1"/>
            <p:nvPr/>
          </p:nvSpPr>
          <p:spPr>
            <a:xfrm>
              <a:off x="1533531" y="3371855"/>
              <a:ext cx="99899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NUP98-Nsd1+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3DFE3B34-823B-4149-ABF7-83B9D22B9642}"/>
                </a:ext>
              </a:extLst>
            </p:cNvPr>
            <p:cNvSpPr txBox="1"/>
            <p:nvPr/>
          </p:nvSpPr>
          <p:spPr>
            <a:xfrm>
              <a:off x="2781315" y="3371858"/>
              <a:ext cx="3834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WT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03BEB14F-626B-488D-BD70-1EB6C28B816A}"/>
                </a:ext>
              </a:extLst>
            </p:cNvPr>
            <p:cNvSpPr txBox="1"/>
            <p:nvPr/>
          </p:nvSpPr>
          <p:spPr>
            <a:xfrm>
              <a:off x="307484" y="3789981"/>
              <a:ext cx="13019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P98-Nsd1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1EFFE05D-A64F-4CF3-A82E-FF9ED0FE338F}"/>
                </a:ext>
              </a:extLst>
            </p:cNvPr>
            <p:cNvSpPr txBox="1"/>
            <p:nvPr/>
          </p:nvSpPr>
          <p:spPr>
            <a:xfrm>
              <a:off x="723711" y="4264796"/>
              <a:ext cx="838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sp>
        <p:nvSpPr>
          <p:cNvPr id="4" name="TextBox 14">
            <a:extLst>
              <a:ext uri="{FF2B5EF4-FFF2-40B4-BE49-F238E27FC236}">
                <a16:creationId xmlns:a16="http://schemas.microsoft.com/office/drawing/2014/main" id="{337B07B4-5AA8-F790-A0CF-79DA65F0D2E2}"/>
              </a:ext>
            </a:extLst>
          </p:cNvPr>
          <p:cNvSpPr txBox="1"/>
          <p:nvPr/>
        </p:nvSpPr>
        <p:spPr>
          <a:xfrm>
            <a:off x="2558786" y="0"/>
            <a:ext cx="26548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. S1</a:t>
            </a:r>
          </a:p>
        </p:txBody>
      </p:sp>
      <p:sp>
        <p:nvSpPr>
          <p:cNvPr id="5" name="TextBox 36">
            <a:extLst>
              <a:ext uri="{FF2B5EF4-FFF2-40B4-BE49-F238E27FC236}">
                <a16:creationId xmlns:a16="http://schemas.microsoft.com/office/drawing/2014/main" id="{60E2741E-1339-118D-AD2C-5088E884F94A}"/>
              </a:ext>
            </a:extLst>
          </p:cNvPr>
          <p:cNvSpPr txBox="1"/>
          <p:nvPr/>
        </p:nvSpPr>
        <p:spPr>
          <a:xfrm>
            <a:off x="491926" y="4503706"/>
            <a:ext cx="6654832" cy="230832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l Figure S</a:t>
            </a:r>
            <a:r>
              <a:rPr lang="en-US" sz="1200" b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.   Generation of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mice on a C57BL/6 background.   </a:t>
            </a:r>
          </a:p>
          <a:p>
            <a:pPr marL="0" marR="0">
              <a:spcBef>
                <a:spcPts val="0"/>
              </a:spcBef>
            </a:pP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A.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chematic of th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pVav1-NUP98::Nsd1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usion used for microinjection. </a:t>
            </a:r>
            <a:r>
              <a:rPr lang="en-US" sz="12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he vector was based on a human-murine </a:t>
            </a:r>
            <a:r>
              <a:rPr lang="en-US" sz="1200" i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 </a:t>
            </a:r>
            <a:r>
              <a:rPr lang="en-US" sz="12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usion that encoded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amino acids 1–518 of NUP98 fused to amino acids 1166-2596 of Nsd1 (see Supplemental Methods). FG (phenylalanine/glycine) repeats, PHD (plant homeodomain) domain, PWWP (proline, tryptophan, tryptophan, proline) motif, SET [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(var)3-9, Enhancer-of-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zeste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rithorax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] domain, and (C/H) cysteine, histidine rich domains are indicated. 5’ and 3’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Vav1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regulatory elements, SV40-derived splice donor, intron, and splice acceptor, and SV40-derived polyadenylation signal, all part of the p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Vav1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vector backbone, are indicated.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B.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Expression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detected by RT-PCR in hematopoietic tissues, but not non-hematopoietic tissues, from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ransgenic mouse. BM (bone marrow) SP (spleen), Kid (kidney), and Liv (liver) are indicated. Amplification of actin was used as an RNA quality control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C.</a:t>
            </a:r>
            <a:r>
              <a:rPr lang="en-US" sz="1200" b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rvival curve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ounders. Two mice developed AML; three mice were found dead of unknown causes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66686B7-5F4B-5831-A81C-D39657B4313E}"/>
              </a:ext>
            </a:extLst>
          </p:cNvPr>
          <p:cNvSpPr/>
          <p:nvPr/>
        </p:nvSpPr>
        <p:spPr>
          <a:xfrm>
            <a:off x="5876926" y="1476373"/>
            <a:ext cx="147631" cy="176213"/>
          </a:xfrm>
          <a:prstGeom prst="rect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3AD2184-0A9C-0EF1-5D85-3DF812FFDC16}"/>
              </a:ext>
            </a:extLst>
          </p:cNvPr>
          <p:cNvSpPr/>
          <p:nvPr/>
        </p:nvSpPr>
        <p:spPr>
          <a:xfrm>
            <a:off x="1781174" y="1476374"/>
            <a:ext cx="238125" cy="176214"/>
          </a:xfrm>
          <a:prstGeom prst="rect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904C19D-C6D6-CE28-B6DA-1C88F6BF6B06}"/>
              </a:ext>
            </a:extLst>
          </p:cNvPr>
          <p:cNvSpPr/>
          <p:nvPr/>
        </p:nvSpPr>
        <p:spPr>
          <a:xfrm>
            <a:off x="1209670" y="1476369"/>
            <a:ext cx="566737" cy="176212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3C6553A-A35A-8652-1785-74DA8F3E2B2A}"/>
              </a:ext>
            </a:extLst>
          </p:cNvPr>
          <p:cNvSpPr/>
          <p:nvPr/>
        </p:nvSpPr>
        <p:spPr>
          <a:xfrm>
            <a:off x="6024558" y="1476369"/>
            <a:ext cx="566737" cy="176212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5BF26B6-64C4-275B-852E-4EF53C4D977A}"/>
              </a:ext>
            </a:extLst>
          </p:cNvPr>
          <p:cNvSpPr txBox="1"/>
          <p:nvPr/>
        </p:nvSpPr>
        <p:spPr>
          <a:xfrm>
            <a:off x="5974923" y="1075572"/>
            <a:ext cx="587802" cy="2055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65785"/>
            <a:r>
              <a:rPr lang="en-US" sz="743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’ Vav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59F769D-A842-8E74-56DB-7F3E337EB06C}"/>
              </a:ext>
            </a:extLst>
          </p:cNvPr>
          <p:cNvSpPr txBox="1"/>
          <p:nvPr/>
        </p:nvSpPr>
        <p:spPr>
          <a:xfrm>
            <a:off x="1212424" y="1046998"/>
            <a:ext cx="587802" cy="2055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65785"/>
            <a:r>
              <a:rPr lang="en-US" sz="743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’ Vav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AE6882B-DD81-DEB2-E477-44C6937123B6}"/>
              </a:ext>
            </a:extLst>
          </p:cNvPr>
          <p:cNvSpPr txBox="1"/>
          <p:nvPr/>
        </p:nvSpPr>
        <p:spPr>
          <a:xfrm>
            <a:off x="1474360" y="1799473"/>
            <a:ext cx="911652" cy="320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565785"/>
            <a:r>
              <a:rPr lang="en-US" sz="743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V40 SD, intron, and S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09F142F-C704-1555-EC0B-E9A3144D8CF4}"/>
              </a:ext>
            </a:extLst>
          </p:cNvPr>
          <p:cNvSpPr txBox="1"/>
          <p:nvPr/>
        </p:nvSpPr>
        <p:spPr>
          <a:xfrm>
            <a:off x="5727273" y="1794711"/>
            <a:ext cx="911652" cy="206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65785"/>
            <a:r>
              <a:rPr lang="en-US" sz="743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V40 PA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93C750F-CA6A-7CE4-2C6E-8E62DCF1C148}"/>
              </a:ext>
            </a:extLst>
          </p:cNvPr>
          <p:cNvCxnSpPr>
            <a:cxnSpLocks/>
          </p:cNvCxnSpPr>
          <p:nvPr/>
        </p:nvCxnSpPr>
        <p:spPr>
          <a:xfrm>
            <a:off x="5968010" y="1694137"/>
            <a:ext cx="0" cy="8840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EE659FE-AFA3-9F2B-6D53-C368995F595C}"/>
              </a:ext>
            </a:extLst>
          </p:cNvPr>
          <p:cNvCxnSpPr>
            <a:cxnSpLocks/>
          </p:cNvCxnSpPr>
          <p:nvPr/>
        </p:nvCxnSpPr>
        <p:spPr>
          <a:xfrm>
            <a:off x="1905594" y="1717940"/>
            <a:ext cx="0" cy="8840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D84CA764-A94D-7C74-642A-E4E25B503FE7}"/>
              </a:ext>
            </a:extLst>
          </p:cNvPr>
          <p:cNvSpPr txBox="1"/>
          <p:nvPr/>
        </p:nvSpPr>
        <p:spPr>
          <a:xfrm>
            <a:off x="5614988" y="2185970"/>
            <a:ext cx="912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AML 181 day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471B0F9-588F-15CE-1C52-5E8CBE1BD562}"/>
              </a:ext>
            </a:extLst>
          </p:cNvPr>
          <p:cNvSpPr txBox="1"/>
          <p:nvPr/>
        </p:nvSpPr>
        <p:spPr>
          <a:xfrm>
            <a:off x="5886450" y="2438382"/>
            <a:ext cx="912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AML 232 days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CC8EBD4-3251-6D2C-6246-20C517BB0975}"/>
              </a:ext>
            </a:extLst>
          </p:cNvPr>
          <p:cNvCxnSpPr>
            <a:cxnSpLocks/>
          </p:cNvCxnSpPr>
          <p:nvPr/>
        </p:nvCxnSpPr>
        <p:spPr>
          <a:xfrm flipH="1">
            <a:off x="5576887" y="2390757"/>
            <a:ext cx="176213" cy="2286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F42AD072-3C52-6E5B-4969-E5A7AC80D294}"/>
              </a:ext>
            </a:extLst>
          </p:cNvPr>
          <p:cNvCxnSpPr>
            <a:cxnSpLocks/>
          </p:cNvCxnSpPr>
          <p:nvPr/>
        </p:nvCxnSpPr>
        <p:spPr>
          <a:xfrm flipH="1">
            <a:off x="5772151" y="2619360"/>
            <a:ext cx="176213" cy="2286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67011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2DC8C8EA-AA07-49A6-9A40-57B099273887}"/>
              </a:ext>
            </a:extLst>
          </p:cNvPr>
          <p:cNvSpPr txBox="1"/>
          <p:nvPr/>
        </p:nvSpPr>
        <p:spPr>
          <a:xfrm>
            <a:off x="2558786" y="0"/>
            <a:ext cx="26548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. 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B4FE811-47C8-4816-A003-3FD948C40669}"/>
              </a:ext>
            </a:extLst>
          </p:cNvPr>
          <p:cNvSpPr txBox="1"/>
          <p:nvPr/>
        </p:nvSpPr>
        <p:spPr>
          <a:xfrm>
            <a:off x="517891" y="3212538"/>
            <a:ext cx="6902505" cy="10361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l Figure. </a:t>
            </a:r>
            <a:r>
              <a:rPr lang="en-US" sz="1200" b="1" dirty="0"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. No difference in survival of F1 generation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and WT mice</a:t>
            </a:r>
            <a:endParaRPr lang="en-US" sz="12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rvival of F1 generation from the A10 founder shows no survival difference between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transgenic mice and WT littermates.</a:t>
            </a:r>
            <a:endParaRPr lang="en-US" sz="12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endParaRPr lang="en-US" sz="1200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3C58552-AE8A-1ACA-9FB0-50E402FA3F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1960978"/>
              </p:ext>
            </p:extLst>
          </p:nvPr>
        </p:nvGraphicFramePr>
        <p:xfrm>
          <a:off x="1346200" y="506413"/>
          <a:ext cx="3840163" cy="2681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840948" imgH="2680513" progId="Prism8.Document">
                  <p:embed/>
                </p:oleObj>
              </mc:Choice>
              <mc:Fallback>
                <p:oleObj name="Prism 8" r:id="rId2" imgW="3840948" imgH="2680513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A87565E7-3B0B-6B02-AF18-7C923BEC49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46200" y="506413"/>
                        <a:ext cx="3840163" cy="2681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649108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64E1D35-4ADB-4038-A076-E1EACE2AB9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9402" y="940022"/>
            <a:ext cx="1336104" cy="133610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6DC5292-5CDF-43C7-B4FF-7C9F1E1ED5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5134" y="947244"/>
            <a:ext cx="1336104" cy="133610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0560FE0-91D5-4998-B767-7C63DC59A3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02719" y="951493"/>
            <a:ext cx="1336104" cy="1336104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579E219-8D47-4840-8157-A17F30FB363F}"/>
              </a:ext>
            </a:extLst>
          </p:cNvPr>
          <p:cNvSpPr txBox="1"/>
          <p:nvPr/>
        </p:nvSpPr>
        <p:spPr>
          <a:xfrm>
            <a:off x="899894" y="2291040"/>
            <a:ext cx="1850992" cy="2446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    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    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    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   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2D31763-2A3B-4C6A-AF24-532A99C06D1D}"/>
              </a:ext>
            </a:extLst>
          </p:cNvPr>
          <p:cNvSpPr txBox="1"/>
          <p:nvPr/>
        </p:nvSpPr>
        <p:spPr>
          <a:xfrm>
            <a:off x="1126036" y="660543"/>
            <a:ext cx="13290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ne marrow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C21D499-F8F6-4124-AB91-F4651BC6B703}"/>
              </a:ext>
            </a:extLst>
          </p:cNvPr>
          <p:cNvSpPr txBox="1"/>
          <p:nvPr/>
        </p:nvSpPr>
        <p:spPr>
          <a:xfrm>
            <a:off x="735558" y="891637"/>
            <a:ext cx="431721" cy="14634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endParaRPr lang="en-US" sz="99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99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99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99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99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99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99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99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A5ED9E3-1E3B-4112-AFA9-F05E768F4CB2}"/>
              </a:ext>
            </a:extLst>
          </p:cNvPr>
          <p:cNvSpPr txBox="1"/>
          <p:nvPr/>
        </p:nvSpPr>
        <p:spPr>
          <a:xfrm>
            <a:off x="2817056" y="660543"/>
            <a:ext cx="794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3DC0D45-7717-461A-B4B5-FB4F12B00C03}"/>
              </a:ext>
            </a:extLst>
          </p:cNvPr>
          <p:cNvSpPr txBox="1"/>
          <p:nvPr/>
        </p:nvSpPr>
        <p:spPr>
          <a:xfrm>
            <a:off x="4364420" y="672774"/>
            <a:ext cx="964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9DC814C-E150-42F4-BBD6-63B9B2F58F54}"/>
              </a:ext>
            </a:extLst>
          </p:cNvPr>
          <p:cNvSpPr txBox="1"/>
          <p:nvPr/>
        </p:nvSpPr>
        <p:spPr>
          <a:xfrm>
            <a:off x="2561986" y="0"/>
            <a:ext cx="2648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. S3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4FACD38-9C09-47AC-BECF-B314C19CC59C}"/>
              </a:ext>
            </a:extLst>
          </p:cNvPr>
          <p:cNvSpPr txBox="1"/>
          <p:nvPr/>
        </p:nvSpPr>
        <p:spPr>
          <a:xfrm>
            <a:off x="585714" y="589188"/>
            <a:ext cx="3649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D99E051-2EC0-4377-847B-E91D5EABACBD}"/>
              </a:ext>
            </a:extLst>
          </p:cNvPr>
          <p:cNvSpPr txBox="1"/>
          <p:nvPr/>
        </p:nvSpPr>
        <p:spPr>
          <a:xfrm>
            <a:off x="2391293" y="2700108"/>
            <a:ext cx="3649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3017E1C-A023-44AB-BCAA-18ADBD007966}"/>
              </a:ext>
            </a:extLst>
          </p:cNvPr>
          <p:cNvSpPr txBox="1"/>
          <p:nvPr/>
        </p:nvSpPr>
        <p:spPr>
          <a:xfrm>
            <a:off x="578587" y="2807810"/>
            <a:ext cx="3649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0C44C145-9642-4772-AFD8-99C5576435A8}"/>
              </a:ext>
            </a:extLst>
          </p:cNvPr>
          <p:cNvCxnSpPr>
            <a:cxnSpLocks/>
          </p:cNvCxnSpPr>
          <p:nvPr/>
        </p:nvCxnSpPr>
        <p:spPr>
          <a:xfrm flipH="1" flipV="1">
            <a:off x="735558" y="2115285"/>
            <a:ext cx="1" cy="444383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7380EF74-FE7D-475D-BB7E-F8D2E0A30AC1}"/>
              </a:ext>
            </a:extLst>
          </p:cNvPr>
          <p:cNvSpPr txBox="1"/>
          <p:nvPr/>
        </p:nvSpPr>
        <p:spPr>
          <a:xfrm>
            <a:off x="735558" y="2590366"/>
            <a:ext cx="762157" cy="231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7" dirty="0">
                <a:latin typeface="Arial" panose="020B0604020202020204" pitchFamily="34" charset="0"/>
                <a:cs typeface="Arial" panose="020B0604020202020204" pitchFamily="34" charset="0"/>
              </a:rPr>
              <a:t>Gr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6FD88EE-FB5B-4D03-89F4-3B2BB78F8926}"/>
              </a:ext>
            </a:extLst>
          </p:cNvPr>
          <p:cNvSpPr txBox="1"/>
          <p:nvPr/>
        </p:nvSpPr>
        <p:spPr>
          <a:xfrm rot="16200000">
            <a:off x="225076" y="2063316"/>
            <a:ext cx="762157" cy="2319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7" dirty="0">
                <a:latin typeface="Arial" panose="020B0604020202020204" pitchFamily="34" charset="0"/>
                <a:cs typeface="Arial" panose="020B0604020202020204" pitchFamily="34" charset="0"/>
              </a:rPr>
              <a:t>Mac1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85A5769D-1C1F-4A2A-979B-BFB8D96C2CF9}"/>
              </a:ext>
            </a:extLst>
          </p:cNvPr>
          <p:cNvCxnSpPr>
            <a:cxnSpLocks/>
          </p:cNvCxnSpPr>
          <p:nvPr/>
        </p:nvCxnSpPr>
        <p:spPr>
          <a:xfrm flipV="1">
            <a:off x="735559" y="2559668"/>
            <a:ext cx="434763" cy="618"/>
          </a:xfrm>
          <a:prstGeom prst="straightConnector1">
            <a:avLst/>
          </a:prstGeom>
          <a:ln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A231E10B-ABE7-4915-8526-2ABB7A26F761}"/>
              </a:ext>
            </a:extLst>
          </p:cNvPr>
          <p:cNvSpPr txBox="1"/>
          <p:nvPr/>
        </p:nvSpPr>
        <p:spPr>
          <a:xfrm>
            <a:off x="685067" y="5041253"/>
            <a:ext cx="14537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B6E6A68-55D4-44D9-AE73-869515359E36}"/>
              </a:ext>
            </a:extLst>
          </p:cNvPr>
          <p:cNvGrpSpPr/>
          <p:nvPr/>
        </p:nvGrpSpPr>
        <p:grpSpPr>
          <a:xfrm>
            <a:off x="2614383" y="2697611"/>
            <a:ext cx="3228623" cy="2540195"/>
            <a:chOff x="2962046" y="5631311"/>
            <a:chExt cx="3228623" cy="2540195"/>
          </a:xfrm>
        </p:grpSpPr>
        <p:pic>
          <p:nvPicPr>
            <p:cNvPr id="9" name="Picture 8" descr="A picture containing text, fabric&#10;&#10;Description automatically generated">
              <a:extLst>
                <a:ext uri="{FF2B5EF4-FFF2-40B4-BE49-F238E27FC236}">
                  <a16:creationId xmlns:a16="http://schemas.microsoft.com/office/drawing/2014/main" id="{15AF1683-48E5-4F80-B251-3DC8B95021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302838" y="5902072"/>
              <a:ext cx="1336102" cy="1046578"/>
            </a:xfrm>
            <a:prstGeom prst="rect">
              <a:avLst/>
            </a:prstGeom>
          </p:spPr>
        </p:pic>
        <p:pic>
          <p:nvPicPr>
            <p:cNvPr id="16" name="Picture 15" descr="A picture containing sugar&#10;&#10;Description automatically generated">
              <a:extLst>
                <a:ext uri="{FF2B5EF4-FFF2-40B4-BE49-F238E27FC236}">
                  <a16:creationId xmlns:a16="http://schemas.microsoft.com/office/drawing/2014/main" id="{43EDC133-559C-4CCE-8375-9D2F139D76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01268" y="5887787"/>
              <a:ext cx="1336103" cy="1046578"/>
            </a:xfrm>
            <a:prstGeom prst="rect">
              <a:avLst/>
            </a:prstGeom>
          </p:spPr>
        </p:pic>
        <p:pic>
          <p:nvPicPr>
            <p:cNvPr id="55" name="Picture 54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8B86E937-C6DC-4129-AE21-CCB53C5706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-257"/>
            <a:stretch/>
          </p:blipFill>
          <p:spPr>
            <a:xfrm>
              <a:off x="3299313" y="7150343"/>
              <a:ext cx="1332788" cy="1021163"/>
            </a:xfrm>
            <a:prstGeom prst="rect">
              <a:avLst/>
            </a:prstGeom>
          </p:spPr>
        </p:pic>
        <p:pic>
          <p:nvPicPr>
            <p:cNvPr id="57" name="Picture 56" descr="A picture containing ground&#10;&#10;Description automatically generated">
              <a:extLst>
                <a:ext uri="{FF2B5EF4-FFF2-40B4-BE49-F238E27FC236}">
                  <a16:creationId xmlns:a16="http://schemas.microsoft.com/office/drawing/2014/main" id="{D05A844A-FB21-4106-8875-45B25F6D73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731"/>
            <a:stretch/>
          </p:blipFill>
          <p:spPr>
            <a:xfrm>
              <a:off x="4796097" y="7136675"/>
              <a:ext cx="1394572" cy="1021163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9A951DA-CB08-4CEF-8990-0B12998A61AE}"/>
                </a:ext>
              </a:extLst>
            </p:cNvPr>
            <p:cNvSpPr txBox="1"/>
            <p:nvPr/>
          </p:nvSpPr>
          <p:spPr>
            <a:xfrm rot="16200000">
              <a:off x="2723400" y="7412951"/>
              <a:ext cx="7621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5AF42E0-454C-40C0-944D-94C45DECD3E1}"/>
                </a:ext>
              </a:extLst>
            </p:cNvPr>
            <p:cNvSpPr txBox="1"/>
            <p:nvPr/>
          </p:nvSpPr>
          <p:spPr>
            <a:xfrm rot="16200000">
              <a:off x="2719467" y="6103940"/>
              <a:ext cx="7621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ung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2C191CAC-393F-46AF-BC75-FA691D2D3201}"/>
                </a:ext>
              </a:extLst>
            </p:cNvPr>
            <p:cNvSpPr txBox="1"/>
            <p:nvPr/>
          </p:nvSpPr>
          <p:spPr>
            <a:xfrm>
              <a:off x="3704555" y="5633217"/>
              <a:ext cx="7621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&amp;E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3D89767-2F14-478D-B582-D246AB33251E}"/>
                </a:ext>
              </a:extLst>
            </p:cNvPr>
            <p:cNvSpPr txBox="1"/>
            <p:nvPr/>
          </p:nvSpPr>
          <p:spPr>
            <a:xfrm>
              <a:off x="5216375" y="5631311"/>
              <a:ext cx="7621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PO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C132D6D4-1C5C-4498-BAFF-FF08FF87FEE2}"/>
                </a:ext>
              </a:extLst>
            </p:cNvPr>
            <p:cNvCxnSpPr>
              <a:cxnSpLocks/>
            </p:cNvCxnSpPr>
            <p:nvPr/>
          </p:nvCxnSpPr>
          <p:spPr>
            <a:xfrm>
              <a:off x="4313355" y="6888170"/>
              <a:ext cx="306714" cy="319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53305AE3-44A1-4175-A42B-43827D8BA3EA}"/>
                </a:ext>
              </a:extLst>
            </p:cNvPr>
            <p:cNvCxnSpPr>
              <a:cxnSpLocks/>
            </p:cNvCxnSpPr>
            <p:nvPr/>
          </p:nvCxnSpPr>
          <p:spPr>
            <a:xfrm>
              <a:off x="4264685" y="8097845"/>
              <a:ext cx="306714" cy="319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536C94A0-DE5D-4F3C-B328-CA31567ADE85}"/>
                </a:ext>
              </a:extLst>
            </p:cNvPr>
            <p:cNvCxnSpPr>
              <a:cxnSpLocks/>
            </p:cNvCxnSpPr>
            <p:nvPr/>
          </p:nvCxnSpPr>
          <p:spPr>
            <a:xfrm>
              <a:off x="5825175" y="6884967"/>
              <a:ext cx="306714" cy="319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B3AF21E1-35F9-48C2-98FA-52BE79951F02}"/>
                </a:ext>
              </a:extLst>
            </p:cNvPr>
            <p:cNvCxnSpPr>
              <a:cxnSpLocks/>
            </p:cNvCxnSpPr>
            <p:nvPr/>
          </p:nvCxnSpPr>
          <p:spPr>
            <a:xfrm>
              <a:off x="5812601" y="8094642"/>
              <a:ext cx="306714" cy="319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664435D9-7711-4655-AED0-C4543E5750B9}"/>
              </a:ext>
            </a:extLst>
          </p:cNvPr>
          <p:cNvGrpSpPr/>
          <p:nvPr/>
        </p:nvGrpSpPr>
        <p:grpSpPr>
          <a:xfrm>
            <a:off x="994993" y="2982437"/>
            <a:ext cx="1059148" cy="1043694"/>
            <a:chOff x="1133106" y="5882800"/>
            <a:chExt cx="1059148" cy="1043694"/>
          </a:xfrm>
        </p:grpSpPr>
        <p:pic>
          <p:nvPicPr>
            <p:cNvPr id="3" name="Picture 2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AB4963FA-B6B9-4F48-AB0A-5C7E183800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33106" y="5882800"/>
              <a:ext cx="1059148" cy="1043694"/>
            </a:xfrm>
            <a:prstGeom prst="rect">
              <a:avLst/>
            </a:prstGeom>
          </p:spPr>
        </p:pic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1858C999-1978-4CD1-87B1-666FCE81825A}"/>
                </a:ext>
              </a:extLst>
            </p:cNvPr>
            <p:cNvCxnSpPr>
              <a:cxnSpLocks/>
            </p:cNvCxnSpPr>
            <p:nvPr/>
          </p:nvCxnSpPr>
          <p:spPr>
            <a:xfrm>
              <a:off x="1167279" y="6898544"/>
              <a:ext cx="31089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E21CFA1B-8E3E-4ED0-A574-62147E1B327E}"/>
              </a:ext>
            </a:extLst>
          </p:cNvPr>
          <p:cNvSpPr txBox="1"/>
          <p:nvPr/>
        </p:nvSpPr>
        <p:spPr>
          <a:xfrm>
            <a:off x="517892" y="7590329"/>
            <a:ext cx="7048162" cy="13849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l Figure S3.   Generation of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mice on a FVB/NJ background.    A. 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Invasion of Mac-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/Gr-1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myeloblasts in bone marrow, spleen, and thymus from mouse MT1502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B.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	Bone marrow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cytospin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from mouse MT1502 showing myeloblasts with high nuclear/cytoplasmic ratio. Scale bar = 50 µm. 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C.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Invasion of liver and lung with MPO-positive myeloblasts. Scale bar = 500 µm.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D.</a:t>
            </a:r>
            <a:r>
              <a:rPr lang="en-US" sz="1200" b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rvival of MT1502 F1 generation shows no difference between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transgenic mice (n = 39) and WT littermates (n = 39).</a:t>
            </a:r>
          </a:p>
          <a:p>
            <a:pPr marL="0" marR="0">
              <a:spcBef>
                <a:spcPts val="0"/>
              </a:spcBef>
            </a:pP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12EEF984-B7EC-37B8-C625-2C0005C262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7402627"/>
              </p:ext>
            </p:extLst>
          </p:nvPr>
        </p:nvGraphicFramePr>
        <p:xfrm>
          <a:off x="1020763" y="5045076"/>
          <a:ext cx="3844925" cy="2681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845627" imgH="2680513" progId="Prism8.Document">
                  <p:embed/>
                </p:oleObj>
              </mc:Choice>
              <mc:Fallback>
                <p:oleObj name="Prism 8" r:id="rId10" imgW="3845627" imgH="2680513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D67EC23-FB85-1503-4FE6-B622F92D6C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020763" y="5045076"/>
                        <a:ext cx="3844925" cy="2681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7014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7E6F8329-FF64-45F1-88C8-A415D7620773}"/>
              </a:ext>
            </a:extLst>
          </p:cNvPr>
          <p:cNvSpPr txBox="1"/>
          <p:nvPr/>
        </p:nvSpPr>
        <p:spPr>
          <a:xfrm>
            <a:off x="2591409" y="0"/>
            <a:ext cx="2647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. S4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8604A7D-FFFA-4894-B5BB-999F27C50E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8471129"/>
              </p:ext>
            </p:extLst>
          </p:nvPr>
        </p:nvGraphicFramePr>
        <p:xfrm>
          <a:off x="241076" y="976863"/>
          <a:ext cx="7287717" cy="422346"/>
        </p:xfrm>
        <a:graphic>
          <a:graphicData uri="http://schemas.openxmlformats.org/drawingml/2006/table">
            <a:tbl>
              <a:tblPr/>
              <a:tblGrid>
                <a:gridCol w="386167">
                  <a:extLst>
                    <a:ext uri="{9D8B030D-6E8A-4147-A177-3AD203B41FA5}">
                      <a16:colId xmlns:a16="http://schemas.microsoft.com/office/drawing/2014/main" val="700794105"/>
                    </a:ext>
                  </a:extLst>
                </a:gridCol>
                <a:gridCol w="255367">
                  <a:extLst>
                    <a:ext uri="{9D8B030D-6E8A-4147-A177-3AD203B41FA5}">
                      <a16:colId xmlns:a16="http://schemas.microsoft.com/office/drawing/2014/main" val="3821968374"/>
                    </a:ext>
                  </a:extLst>
                </a:gridCol>
                <a:gridCol w="566792">
                  <a:extLst>
                    <a:ext uri="{9D8B030D-6E8A-4147-A177-3AD203B41FA5}">
                      <a16:colId xmlns:a16="http://schemas.microsoft.com/office/drawing/2014/main" val="664245155"/>
                    </a:ext>
                  </a:extLst>
                </a:gridCol>
                <a:gridCol w="591704">
                  <a:extLst>
                    <a:ext uri="{9D8B030D-6E8A-4147-A177-3AD203B41FA5}">
                      <a16:colId xmlns:a16="http://schemas.microsoft.com/office/drawing/2014/main" val="3640382830"/>
                    </a:ext>
                  </a:extLst>
                </a:gridCol>
                <a:gridCol w="250141">
                  <a:extLst>
                    <a:ext uri="{9D8B030D-6E8A-4147-A177-3AD203B41FA5}">
                      <a16:colId xmlns:a16="http://schemas.microsoft.com/office/drawing/2014/main" val="800348745"/>
                    </a:ext>
                  </a:extLst>
                </a:gridCol>
                <a:gridCol w="241905">
                  <a:extLst>
                    <a:ext uri="{9D8B030D-6E8A-4147-A177-3AD203B41FA5}">
                      <a16:colId xmlns:a16="http://schemas.microsoft.com/office/drawing/2014/main" val="188403065"/>
                    </a:ext>
                  </a:extLst>
                </a:gridCol>
                <a:gridCol w="512550">
                  <a:extLst>
                    <a:ext uri="{9D8B030D-6E8A-4147-A177-3AD203B41FA5}">
                      <a16:colId xmlns:a16="http://schemas.microsoft.com/office/drawing/2014/main" val="488249760"/>
                    </a:ext>
                  </a:extLst>
                </a:gridCol>
                <a:gridCol w="670860">
                  <a:extLst>
                    <a:ext uri="{9D8B030D-6E8A-4147-A177-3AD203B41FA5}">
                      <a16:colId xmlns:a16="http://schemas.microsoft.com/office/drawing/2014/main" val="775590544"/>
                    </a:ext>
                  </a:extLst>
                </a:gridCol>
                <a:gridCol w="703818">
                  <a:extLst>
                    <a:ext uri="{9D8B030D-6E8A-4147-A177-3AD203B41FA5}">
                      <a16:colId xmlns:a16="http://schemas.microsoft.com/office/drawing/2014/main" val="3799573983"/>
                    </a:ext>
                  </a:extLst>
                </a:gridCol>
                <a:gridCol w="678904">
                  <a:extLst>
                    <a:ext uri="{9D8B030D-6E8A-4147-A177-3AD203B41FA5}">
                      <a16:colId xmlns:a16="http://schemas.microsoft.com/office/drawing/2014/main" val="2437236688"/>
                    </a:ext>
                  </a:extLst>
                </a:gridCol>
                <a:gridCol w="828385">
                  <a:extLst>
                    <a:ext uri="{9D8B030D-6E8A-4147-A177-3AD203B41FA5}">
                      <a16:colId xmlns:a16="http://schemas.microsoft.com/office/drawing/2014/main" val="2547497584"/>
                    </a:ext>
                  </a:extLst>
                </a:gridCol>
                <a:gridCol w="946729">
                  <a:extLst>
                    <a:ext uri="{9D8B030D-6E8A-4147-A177-3AD203B41FA5}">
                      <a16:colId xmlns:a16="http://schemas.microsoft.com/office/drawing/2014/main" val="3704532103"/>
                    </a:ext>
                  </a:extLst>
                </a:gridCol>
                <a:gridCol w="654395">
                  <a:extLst>
                    <a:ext uri="{9D8B030D-6E8A-4147-A177-3AD203B41FA5}">
                      <a16:colId xmlns:a16="http://schemas.microsoft.com/office/drawing/2014/main" val="953181839"/>
                    </a:ext>
                  </a:extLst>
                </a:gridCol>
              </a:tblGrid>
              <a:tr h="97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ample</a:t>
                      </a:r>
                    </a:p>
                  </a:txBody>
                  <a:tcPr marL="3622" marR="3622" marT="362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art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nd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F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T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ene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GVS.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GVS.p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eature_I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notation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notation_Impac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F_TUMOR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6250310"/>
                  </a:ext>
                </a:extLst>
              </a:tr>
              <a:tr h="724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704</a:t>
                      </a:r>
                    </a:p>
                  </a:txBody>
                  <a:tcPr marL="3622" marR="3622" marT="362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r2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6467702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6467702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ch1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.4915G&gt;A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.Ala1639Thr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M_008714.3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ssense_varian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ODERATE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545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7813049"/>
                  </a:ext>
                </a:extLst>
              </a:tr>
              <a:tr h="7243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K717</a:t>
                      </a:r>
                    </a:p>
                  </a:txBody>
                  <a:tcPr marL="3622" marR="3622" marT="362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r4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1163691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1163691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Jak1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.1951T&gt;C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.Tyr651His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M_146145.2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issense_varian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ODERATE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271</a:t>
                      </a:r>
                    </a:p>
                  </a:txBody>
                  <a:tcPr marL="3622" marR="3622" marT="362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8318212"/>
                  </a:ext>
                </a:extLst>
              </a:tr>
            </a:tbl>
          </a:graphicData>
        </a:graphic>
      </p:graphicFrame>
      <p:sp>
        <p:nvSpPr>
          <p:cNvPr id="76" name="TextBox 75">
            <a:extLst>
              <a:ext uri="{FF2B5EF4-FFF2-40B4-BE49-F238E27FC236}">
                <a16:creationId xmlns:a16="http://schemas.microsoft.com/office/drawing/2014/main" id="{7577B4C1-7788-4EC0-BE30-528A58B17A80}"/>
              </a:ext>
            </a:extLst>
          </p:cNvPr>
          <p:cNvSpPr txBox="1"/>
          <p:nvPr/>
        </p:nvSpPr>
        <p:spPr>
          <a:xfrm>
            <a:off x="208724" y="664155"/>
            <a:ext cx="3649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3C01EC7-3F82-4F7C-92CF-667D5FC7A201}"/>
              </a:ext>
            </a:extLst>
          </p:cNvPr>
          <p:cNvSpPr txBox="1"/>
          <p:nvPr/>
        </p:nvSpPr>
        <p:spPr>
          <a:xfrm>
            <a:off x="479454" y="4312868"/>
            <a:ext cx="7151336" cy="83099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l Figure S4. Acquired SNV are rare in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/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LT3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-ITD leukemia.  A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.  No recurrent Tier 1 somatic mutations were identified; one leukemia each had a mutation in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otch1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or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Jak1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.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B.</a:t>
            </a:r>
            <a:r>
              <a:rPr lang="en-US" sz="1200" b="1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Loss of WT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lt3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allele in AML samples. Samples K731, K708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K693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,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K704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have lost the WT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lt3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allele in the AML sample. M; 100 bp ladder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84EC09E-F6ED-F618-2E61-DB348D39D6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38" y="1761153"/>
            <a:ext cx="7772400" cy="1821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76570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6A96C8D-2D86-4E7A-B319-BF64D7408C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685" y="916076"/>
            <a:ext cx="4726251" cy="4572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FEF3789-5270-4202-99FE-2965076117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7463" y="1774394"/>
            <a:ext cx="291265" cy="75115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77F83F3-C375-41DD-9E5F-6BF324F1CF35}"/>
              </a:ext>
            </a:extLst>
          </p:cNvPr>
          <p:cNvSpPr txBox="1"/>
          <p:nvPr/>
        </p:nvSpPr>
        <p:spPr>
          <a:xfrm>
            <a:off x="4698421" y="2038630"/>
            <a:ext cx="8582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WT Whole B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E3BFEB-4AAA-4556-A615-555B51B2DFCE}"/>
              </a:ext>
            </a:extLst>
          </p:cNvPr>
          <p:cNvSpPr txBox="1"/>
          <p:nvPr/>
        </p:nvSpPr>
        <p:spPr>
          <a:xfrm>
            <a:off x="4698420" y="1794418"/>
            <a:ext cx="1615431" cy="2442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AML(NUP98-Nsd1/FLT3-ITD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6F0CB9E-966D-40F2-ABF4-B683C28DF6F3}"/>
              </a:ext>
            </a:extLst>
          </p:cNvPr>
          <p:cNvSpPr txBox="1"/>
          <p:nvPr/>
        </p:nvSpPr>
        <p:spPr>
          <a:xfrm>
            <a:off x="4698421" y="2276569"/>
            <a:ext cx="1436368" cy="2442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WT Lineage Negative B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F824CFF-82B3-4750-920C-D34BC7E60D33}"/>
              </a:ext>
            </a:extLst>
          </p:cNvPr>
          <p:cNvSpPr txBox="1"/>
          <p:nvPr/>
        </p:nvSpPr>
        <p:spPr>
          <a:xfrm>
            <a:off x="2534020" y="116115"/>
            <a:ext cx="2704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 Fig. S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5B11857-7026-4AC0-8F59-EFAF779C9B23}"/>
              </a:ext>
            </a:extLst>
          </p:cNvPr>
          <p:cNvSpPr txBox="1"/>
          <p:nvPr/>
        </p:nvSpPr>
        <p:spPr>
          <a:xfrm>
            <a:off x="375557" y="5741351"/>
            <a:ext cx="685981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5.  Clear separation between AML, WT BM, and WT Lineage Negative BM cells.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 plot was generated using normalized RNA-Seq gene expression for 7 AML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P98::Nsd1/FLT3-IT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4 WT BM, and 4 WT Lin Neg BM samples.</a:t>
            </a:r>
          </a:p>
        </p:txBody>
      </p:sp>
    </p:spTree>
    <p:extLst>
      <p:ext uri="{BB962C8B-B14F-4D97-AF65-F5344CB8AC3E}">
        <p14:creationId xmlns:p14="http://schemas.microsoft.com/office/powerpoint/2010/main" val="33628586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F6A0C43A-553E-408E-AFD5-354951DB42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864" y="822425"/>
            <a:ext cx="5488271" cy="32004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72B2B53-7E94-4FEA-A9EF-C26B7DC82C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5008" y="699287"/>
            <a:ext cx="414375" cy="22901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388A600-1C57-4000-AD79-40BA52E8520D}"/>
              </a:ext>
            </a:extLst>
          </p:cNvPr>
          <p:cNvSpPr txBox="1"/>
          <p:nvPr/>
        </p:nvSpPr>
        <p:spPr>
          <a:xfrm>
            <a:off x="489639" y="850134"/>
            <a:ext cx="468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-1.5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F15C932-88A0-4233-9D92-B1FF7C08BB1F}"/>
              </a:ext>
            </a:extLst>
          </p:cNvPr>
          <p:cNvSpPr txBox="1"/>
          <p:nvPr/>
        </p:nvSpPr>
        <p:spPr>
          <a:xfrm>
            <a:off x="852195" y="850134"/>
            <a:ext cx="2237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BF9BDB7-5F04-4681-AD83-43E412619BDC}"/>
              </a:ext>
            </a:extLst>
          </p:cNvPr>
          <p:cNvSpPr txBox="1"/>
          <p:nvPr/>
        </p:nvSpPr>
        <p:spPr>
          <a:xfrm>
            <a:off x="978039" y="850134"/>
            <a:ext cx="409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0.8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8AD5573-FA9C-4D71-802C-E75B3EDB82B3}"/>
              </a:ext>
            </a:extLst>
          </p:cNvPr>
          <p:cNvSpPr txBox="1"/>
          <p:nvPr/>
        </p:nvSpPr>
        <p:spPr>
          <a:xfrm>
            <a:off x="189703" y="464589"/>
            <a:ext cx="1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066E15C-1423-47F1-ABEA-2AA871ACB1FF}"/>
              </a:ext>
            </a:extLst>
          </p:cNvPr>
          <p:cNvSpPr txBox="1"/>
          <p:nvPr/>
        </p:nvSpPr>
        <p:spPr>
          <a:xfrm>
            <a:off x="189703" y="4102586"/>
            <a:ext cx="1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AD9F0B2-8FD7-7887-3CCB-732B94128170}"/>
              </a:ext>
            </a:extLst>
          </p:cNvPr>
          <p:cNvGrpSpPr/>
          <p:nvPr/>
        </p:nvGrpSpPr>
        <p:grpSpPr>
          <a:xfrm>
            <a:off x="735030" y="4245470"/>
            <a:ext cx="5570520" cy="2247034"/>
            <a:chOff x="735030" y="6392153"/>
            <a:chExt cx="5393862" cy="2560320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1FFA0D1E-F466-FF7C-39B9-6A08C256E2C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35030" y="6392153"/>
              <a:ext cx="2560320" cy="2560320"/>
              <a:chOff x="471045" y="3662301"/>
              <a:chExt cx="2852447" cy="2852447"/>
            </a:xfrm>
          </p:grpSpPr>
          <p:pic>
            <p:nvPicPr>
              <p:cNvPr id="19" name="Picture 2">
                <a:extLst>
                  <a:ext uri="{FF2B5EF4-FFF2-40B4-BE49-F238E27FC236}">
                    <a16:creationId xmlns:a16="http://schemas.microsoft.com/office/drawing/2014/main" id="{CA21B12B-F19A-B5E2-C985-8F2665A12A4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1045" y="3662301"/>
                <a:ext cx="2852447" cy="285244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0" name="TextBox 12">
                <a:extLst>
                  <a:ext uri="{FF2B5EF4-FFF2-40B4-BE49-F238E27FC236}">
                    <a16:creationId xmlns:a16="http://schemas.microsoft.com/office/drawing/2014/main" id="{D4185573-4867-38E1-EC8A-351A7D887C1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78029" y="5530606"/>
                <a:ext cx="1098378" cy="1690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b">
                <a:spAutoFit/>
              </a:bodyPr>
              <a:lstStyle>
                <a:lvl1pPr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Arial" pitchFamily="34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itchFamily="34" charset="0"/>
                  <a:buChar char="•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chemeClr val="accent1"/>
                  </a:buClr>
                  <a:buSzPct val="90000"/>
                  <a:buFont typeface="Arial" pitchFamily="34" charset="0"/>
                  <a:buChar char="•"/>
                  <a:defRPr>
                    <a:solidFill>
                      <a:schemeClr val="tx1"/>
                    </a:solidFill>
                    <a:latin typeface="Arial" pitchFamily="34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chemeClr val="accent1"/>
                  </a:buClr>
                  <a:buFont typeface="Arial" pitchFamily="34" charset="0"/>
                  <a:buChar char="•"/>
                  <a:defRPr sz="1600">
                    <a:solidFill>
                      <a:schemeClr val="tx1"/>
                    </a:solidFill>
                    <a:latin typeface="Arial" pitchFamily="34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9pPr>
              </a:lstStyle>
              <a:p>
                <a:pPr algn="ctr">
                  <a:lnSpc>
                    <a:spcPts val="450"/>
                  </a:lnSpc>
                  <a:spcBef>
                    <a:spcPct val="0"/>
                  </a:spcBef>
                  <a:buClrTx/>
                  <a:buSzTx/>
                  <a:buNone/>
                  <a:defRPr/>
                </a:pPr>
                <a:r>
                  <a:rPr lang="en-US" altLang="en-US" sz="1000" dirty="0">
                    <a:solidFill>
                      <a:srgbClr val="FF0000"/>
                    </a:solidFill>
                    <a:latin typeface="Arial Narrow" panose="020B0606020202030204" pitchFamily="34" charset="0"/>
                    <a:cs typeface="Arial" charset="0"/>
                  </a:rPr>
                  <a:t>AML(NN/FLT3-ITD)</a:t>
                </a:r>
                <a:endParaRPr lang="en-US" altLang="en-US" sz="1000" dirty="0">
                  <a:solidFill>
                    <a:srgbClr val="FF000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A85DB047-67E7-AEB3-1BB4-A3F642D7F9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66082" y="5529752"/>
                <a:ext cx="837089" cy="1690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b">
                <a:spAutoFit/>
              </a:bodyPr>
              <a:lstStyle>
                <a:lvl1pPr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Arial" pitchFamily="34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itchFamily="34" charset="0"/>
                  <a:buChar char="•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chemeClr val="accent1"/>
                  </a:buClr>
                  <a:buSzPct val="90000"/>
                  <a:buFont typeface="Arial" pitchFamily="34" charset="0"/>
                  <a:buChar char="•"/>
                  <a:defRPr>
                    <a:solidFill>
                      <a:schemeClr val="tx1"/>
                    </a:solidFill>
                    <a:latin typeface="Arial" pitchFamily="34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chemeClr val="accent1"/>
                  </a:buClr>
                  <a:buFont typeface="Arial" pitchFamily="34" charset="0"/>
                  <a:buChar char="•"/>
                  <a:defRPr sz="1600">
                    <a:solidFill>
                      <a:schemeClr val="tx1"/>
                    </a:solidFill>
                    <a:latin typeface="Arial" pitchFamily="34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9pPr>
              </a:lstStyle>
              <a:p>
                <a:pPr algn="ctr">
                  <a:lnSpc>
                    <a:spcPts val="450"/>
                  </a:lnSpc>
                  <a:spcBef>
                    <a:spcPct val="0"/>
                  </a:spcBef>
                  <a:buClrTx/>
                  <a:buSzTx/>
                  <a:buNone/>
                  <a:defRPr/>
                </a:pPr>
                <a:r>
                  <a:rPr lang="en-US" altLang="en-US" sz="1000" dirty="0" err="1">
                    <a:solidFill>
                      <a:schemeClr val="accent1"/>
                    </a:solidFill>
                    <a:latin typeface="Arial Narrow" panose="020B0606020202030204" pitchFamily="34" charset="0"/>
                    <a:cs typeface="Arial" charset="0"/>
                  </a:rPr>
                  <a:t>WTLinNegBM</a:t>
                </a:r>
                <a:endParaRPr lang="en-US" altLang="en-US" sz="1000" dirty="0">
                  <a:solidFill>
                    <a:schemeClr val="accent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5BAAA71-AFF7-8D9D-D45C-8AFB6051ED6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067704" y="4581621"/>
                <a:ext cx="1056700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chemeClr val="accent1"/>
                  </a:buClr>
                  <a:buSzPct val="90000"/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chemeClr val="accent1"/>
                  </a:buClr>
                  <a:buFont typeface="Arial" panose="020B0604020202020204" pitchFamily="34" charset="0"/>
                  <a:buChar char="•"/>
                  <a:defRPr sz="16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en-US" altLang="en-US" sz="1000" dirty="0">
                    <a:latin typeface="Arial Narrow" panose="020B0606020202030204" pitchFamily="34" charset="0"/>
                  </a:rPr>
                  <a:t>NES=6.09</a:t>
                </a:r>
              </a:p>
              <a:p>
                <a:pPr eaLnBrk="1" hangingPunct="1"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en-US" altLang="en-US" sz="1000" dirty="0">
                    <a:latin typeface="Arial Narrow" panose="020B0606020202030204" pitchFamily="34" charset="0"/>
                  </a:rPr>
                  <a:t>FDR q value= 0.00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A69FB79-E451-EB7F-6CF6-9D5AD61FAF8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568572" y="6392153"/>
              <a:ext cx="2560320" cy="2560320"/>
              <a:chOff x="3686907" y="3662301"/>
              <a:chExt cx="2852447" cy="2852447"/>
            </a:xfrm>
          </p:grpSpPr>
          <p:pic>
            <p:nvPicPr>
              <p:cNvPr id="8" name="Picture 8">
                <a:extLst>
                  <a:ext uri="{FF2B5EF4-FFF2-40B4-BE49-F238E27FC236}">
                    <a16:creationId xmlns:a16="http://schemas.microsoft.com/office/drawing/2014/main" id="{F76159A2-7095-877F-08B4-6C60F4FDA30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86907" y="3662301"/>
                <a:ext cx="2852447" cy="285244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" name="TextBox 12">
                <a:extLst>
                  <a:ext uri="{FF2B5EF4-FFF2-40B4-BE49-F238E27FC236}">
                    <a16:creationId xmlns:a16="http://schemas.microsoft.com/office/drawing/2014/main" id="{7AB8BD91-61CC-B429-DF8F-E6FF8C121BC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156305" y="5530606"/>
                <a:ext cx="1098378" cy="1690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b">
                <a:spAutoFit/>
              </a:bodyPr>
              <a:lstStyle>
                <a:lvl1pPr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Arial" pitchFamily="34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itchFamily="34" charset="0"/>
                  <a:buChar char="•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chemeClr val="accent1"/>
                  </a:buClr>
                  <a:buSzPct val="90000"/>
                  <a:buFont typeface="Arial" pitchFamily="34" charset="0"/>
                  <a:buChar char="•"/>
                  <a:defRPr>
                    <a:solidFill>
                      <a:schemeClr val="tx1"/>
                    </a:solidFill>
                    <a:latin typeface="Arial" pitchFamily="34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chemeClr val="accent1"/>
                  </a:buClr>
                  <a:buFont typeface="Arial" pitchFamily="34" charset="0"/>
                  <a:buChar char="•"/>
                  <a:defRPr sz="1600">
                    <a:solidFill>
                      <a:schemeClr val="tx1"/>
                    </a:solidFill>
                    <a:latin typeface="Arial" pitchFamily="34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9pPr>
              </a:lstStyle>
              <a:p>
                <a:pPr algn="ctr">
                  <a:lnSpc>
                    <a:spcPts val="450"/>
                  </a:lnSpc>
                  <a:spcBef>
                    <a:spcPct val="0"/>
                  </a:spcBef>
                  <a:buClrTx/>
                  <a:buSzTx/>
                  <a:buNone/>
                  <a:defRPr/>
                </a:pPr>
                <a:r>
                  <a:rPr lang="en-US" altLang="en-US" sz="1000" dirty="0">
                    <a:solidFill>
                      <a:srgbClr val="FF0000"/>
                    </a:solidFill>
                    <a:latin typeface="Arial Narrow" panose="020B0606020202030204" pitchFamily="34" charset="0"/>
                    <a:cs typeface="Arial" charset="0"/>
                  </a:rPr>
                  <a:t>AML(NN/FLT3-ITD)</a:t>
                </a:r>
                <a:endParaRPr lang="en-US" altLang="en-US" sz="1000" dirty="0">
                  <a:solidFill>
                    <a:srgbClr val="FF0000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2347A66-1005-EC4A-8138-52DEDD2EF78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44358" y="5529752"/>
                <a:ext cx="837089" cy="1690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b">
                <a:spAutoFit/>
              </a:bodyPr>
              <a:lstStyle>
                <a:lvl1pPr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Arial" pitchFamily="34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itchFamily="34" charset="0"/>
                  <a:buChar char="•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chemeClr val="accent1"/>
                  </a:buClr>
                  <a:buSzPct val="90000"/>
                  <a:buFont typeface="Arial" pitchFamily="34" charset="0"/>
                  <a:buChar char="•"/>
                  <a:defRPr>
                    <a:solidFill>
                      <a:schemeClr val="tx1"/>
                    </a:solidFill>
                    <a:latin typeface="Arial" pitchFamily="34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chemeClr val="accent1"/>
                  </a:buClr>
                  <a:buFont typeface="Arial" pitchFamily="34" charset="0"/>
                  <a:buChar char="•"/>
                  <a:defRPr sz="1600">
                    <a:solidFill>
                      <a:schemeClr val="tx1"/>
                    </a:solidFill>
                    <a:latin typeface="Arial" pitchFamily="34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itchFamily="34" charset="0"/>
                  <a:buChar char="•"/>
                  <a:defRPr sz="1400">
                    <a:solidFill>
                      <a:schemeClr val="tx1"/>
                    </a:solidFill>
                    <a:latin typeface="Arial" pitchFamily="34" charset="0"/>
                  </a:defRPr>
                </a:lvl9pPr>
              </a:lstStyle>
              <a:p>
                <a:pPr algn="ctr">
                  <a:lnSpc>
                    <a:spcPts val="450"/>
                  </a:lnSpc>
                  <a:spcBef>
                    <a:spcPct val="0"/>
                  </a:spcBef>
                  <a:buClrTx/>
                  <a:buSzTx/>
                  <a:buNone/>
                  <a:defRPr/>
                </a:pPr>
                <a:r>
                  <a:rPr lang="en-US" altLang="en-US" sz="1000" dirty="0" err="1">
                    <a:solidFill>
                      <a:schemeClr val="accent1"/>
                    </a:solidFill>
                    <a:latin typeface="Arial Narrow" panose="020B0606020202030204" pitchFamily="34" charset="0"/>
                    <a:cs typeface="Arial" charset="0"/>
                  </a:rPr>
                  <a:t>WTLinNegBM</a:t>
                </a:r>
                <a:endParaRPr lang="en-US" altLang="en-US" sz="1000" dirty="0">
                  <a:solidFill>
                    <a:schemeClr val="accent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DF6B90C-C400-6F4F-D91E-7CC8903A63F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48259" y="4581621"/>
                <a:ext cx="1056700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chemeClr val="accent1"/>
                  </a:buClr>
                  <a:buSzPct val="85000"/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chemeClr val="accent1"/>
                  </a:buClr>
                  <a:buSzPct val="90000"/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chemeClr val="accent1"/>
                  </a:buClr>
                  <a:buFont typeface="Arial" panose="020B0604020202020204" pitchFamily="34" charset="0"/>
                  <a:buChar char="•"/>
                  <a:defRPr sz="16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accent1"/>
                  </a:buClr>
                  <a:buSzPct val="100000"/>
                  <a:buFont typeface="Arial" panose="020B0604020202020204" pitchFamily="34" charset="0"/>
                  <a:buChar char="•"/>
                  <a:defRPr sz="1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en-US" altLang="en-US" sz="1000" dirty="0">
                    <a:latin typeface="Arial Narrow" panose="020B0606020202030204" pitchFamily="34" charset="0"/>
                  </a:rPr>
                  <a:t>NES=5.89</a:t>
                </a:r>
              </a:p>
              <a:p>
                <a:pPr eaLnBrk="1" hangingPunct="1">
                  <a:spcBef>
                    <a:spcPct val="0"/>
                  </a:spcBef>
                  <a:buClrTx/>
                  <a:buSzTx/>
                  <a:buFontTx/>
                  <a:buNone/>
                </a:pPr>
                <a:r>
                  <a:rPr lang="en-US" altLang="en-US" sz="1000" dirty="0">
                    <a:latin typeface="Arial Narrow" panose="020B0606020202030204" pitchFamily="34" charset="0"/>
                  </a:rPr>
                  <a:t>FDR q value= 0.00</a:t>
                </a:r>
              </a:p>
            </p:txBody>
          </p:sp>
        </p:grp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E64EE4F7-77E6-75FC-81FF-A76391258BC4}"/>
              </a:ext>
            </a:extLst>
          </p:cNvPr>
          <p:cNvSpPr txBox="1"/>
          <p:nvPr/>
        </p:nvSpPr>
        <p:spPr>
          <a:xfrm>
            <a:off x="2558786" y="40460"/>
            <a:ext cx="26548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. S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22C82D9-17BB-ADB3-F583-C0FEFEA99D05}"/>
              </a:ext>
            </a:extLst>
          </p:cNvPr>
          <p:cNvSpPr txBox="1"/>
          <p:nvPr/>
        </p:nvSpPr>
        <p:spPr>
          <a:xfrm>
            <a:off x="323682" y="6655381"/>
            <a:ext cx="7307107" cy="83099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igure S6. RNA-Seq reveals monocytic/macrophage features similar to human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AML.  A. 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Dendrogram and heat map showing unsupervised hierarchical clustering of the three sample group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B.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	GSEA plots showing normalized enrichment scores (NES) and false discovery rate (FDR) q values for the indicated gene sets.</a:t>
            </a:r>
            <a:endParaRPr lang="en-US" sz="12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74169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Teams&#10;&#10;Description automatically generated">
            <a:extLst>
              <a:ext uri="{FF2B5EF4-FFF2-40B4-BE49-F238E27FC236}">
                <a16:creationId xmlns:a16="http://schemas.microsoft.com/office/drawing/2014/main" id="{EC39C0F1-AF6B-1314-1200-FB6B006DDD3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37226" y="1666875"/>
            <a:ext cx="6744946" cy="4468032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16131E6-0B5D-0E75-D6A6-5FBBDF9E47CA}"/>
              </a:ext>
            </a:extLst>
          </p:cNvPr>
          <p:cNvCxnSpPr/>
          <p:nvPr/>
        </p:nvCxnSpPr>
        <p:spPr>
          <a:xfrm flipV="1">
            <a:off x="847725" y="5029200"/>
            <a:ext cx="0" cy="6858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247BE0D0-268B-EB80-944D-6D1DA9C429D6}"/>
              </a:ext>
            </a:extLst>
          </p:cNvPr>
          <p:cNvCxnSpPr>
            <a:cxnSpLocks/>
          </p:cNvCxnSpPr>
          <p:nvPr/>
        </p:nvCxnSpPr>
        <p:spPr>
          <a:xfrm>
            <a:off x="847725" y="5715000"/>
            <a:ext cx="46672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419DCBDC-9D83-0F0A-112D-3BB0FF4C1C26}"/>
              </a:ext>
            </a:extLst>
          </p:cNvPr>
          <p:cNvCxnSpPr/>
          <p:nvPr/>
        </p:nvCxnSpPr>
        <p:spPr>
          <a:xfrm flipV="1">
            <a:off x="857250" y="1990725"/>
            <a:ext cx="0" cy="6858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AFF89F8B-CCAB-9B0B-6E01-421FCCE0D66D}"/>
              </a:ext>
            </a:extLst>
          </p:cNvPr>
          <p:cNvCxnSpPr>
            <a:cxnSpLocks/>
          </p:cNvCxnSpPr>
          <p:nvPr/>
        </p:nvCxnSpPr>
        <p:spPr>
          <a:xfrm>
            <a:off x="857250" y="2676525"/>
            <a:ext cx="46672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E03F836-6AC3-C152-D2BA-1B5FFC8F3CC2}"/>
              </a:ext>
            </a:extLst>
          </p:cNvPr>
          <p:cNvCxnSpPr/>
          <p:nvPr/>
        </p:nvCxnSpPr>
        <p:spPr>
          <a:xfrm flipV="1">
            <a:off x="857250" y="3419475"/>
            <a:ext cx="0" cy="6858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2F3E5222-45EB-90AC-5205-A87C1ABAC01D}"/>
              </a:ext>
            </a:extLst>
          </p:cNvPr>
          <p:cNvCxnSpPr>
            <a:cxnSpLocks/>
          </p:cNvCxnSpPr>
          <p:nvPr/>
        </p:nvCxnSpPr>
        <p:spPr>
          <a:xfrm>
            <a:off x="857250" y="4105275"/>
            <a:ext cx="46672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BDFC18B4-C78F-37E7-6E40-A81F6DC92DF6}"/>
              </a:ext>
            </a:extLst>
          </p:cNvPr>
          <p:cNvSpPr txBox="1"/>
          <p:nvPr/>
        </p:nvSpPr>
        <p:spPr>
          <a:xfrm rot="-5400000">
            <a:off x="309388" y="2157236"/>
            <a:ext cx="73449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Mac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E49BE28-BFD7-6E8E-D56A-B3ADDE30F882}"/>
              </a:ext>
            </a:extLst>
          </p:cNvPr>
          <p:cNvSpPr txBox="1"/>
          <p:nvPr/>
        </p:nvSpPr>
        <p:spPr>
          <a:xfrm>
            <a:off x="828675" y="2658248"/>
            <a:ext cx="4138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Gr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A53BDEF-FF43-7CF5-2232-CB441B979AB6}"/>
              </a:ext>
            </a:extLst>
          </p:cNvPr>
          <p:cNvSpPr txBox="1"/>
          <p:nvPr/>
        </p:nvSpPr>
        <p:spPr>
          <a:xfrm rot="-5400000">
            <a:off x="316607" y="3579079"/>
            <a:ext cx="73449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D16/3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BCB0696-D36F-AC75-245D-D7FB7BE4009D}"/>
              </a:ext>
            </a:extLst>
          </p:cNvPr>
          <p:cNvSpPr txBox="1"/>
          <p:nvPr/>
        </p:nvSpPr>
        <p:spPr>
          <a:xfrm>
            <a:off x="752475" y="4048898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D1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5CD1910-FD1C-C15A-41D2-7536F1B1FBFB}"/>
              </a:ext>
            </a:extLst>
          </p:cNvPr>
          <p:cNvSpPr txBox="1"/>
          <p:nvPr/>
        </p:nvSpPr>
        <p:spPr>
          <a:xfrm>
            <a:off x="736444" y="5668147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4/8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BBF7433-7ED1-C3E9-3722-E8DF89399D89}"/>
              </a:ext>
            </a:extLst>
          </p:cNvPr>
          <p:cNvSpPr txBox="1"/>
          <p:nvPr/>
        </p:nvSpPr>
        <p:spPr>
          <a:xfrm>
            <a:off x="1084998" y="1298702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62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832EFE8-F9F8-289F-E286-C90AAE1FC962}"/>
              </a:ext>
            </a:extLst>
          </p:cNvPr>
          <p:cNvSpPr txBox="1"/>
          <p:nvPr/>
        </p:nvSpPr>
        <p:spPr>
          <a:xfrm>
            <a:off x="6474370" y="1306188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74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DBD0A0F-F030-4F8C-D074-A8A26A31DFD2}"/>
              </a:ext>
            </a:extLst>
          </p:cNvPr>
          <p:cNvSpPr txBox="1"/>
          <p:nvPr/>
        </p:nvSpPr>
        <p:spPr>
          <a:xfrm>
            <a:off x="5199164" y="1298702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74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AA64914-3B48-ED2A-D4EB-9F2FD90BB731}"/>
              </a:ext>
            </a:extLst>
          </p:cNvPr>
          <p:cNvSpPr txBox="1"/>
          <p:nvPr/>
        </p:nvSpPr>
        <p:spPr>
          <a:xfrm>
            <a:off x="3735668" y="1305505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70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F4DA7B-9F7D-B035-783A-69A8E41AA4EE}"/>
              </a:ext>
            </a:extLst>
          </p:cNvPr>
          <p:cNvSpPr txBox="1"/>
          <p:nvPr/>
        </p:nvSpPr>
        <p:spPr>
          <a:xfrm>
            <a:off x="2347578" y="1297543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68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480425C-DEE4-4EB3-9803-724EB351F942}"/>
              </a:ext>
            </a:extLst>
          </p:cNvPr>
          <p:cNvSpPr txBox="1"/>
          <p:nvPr/>
        </p:nvSpPr>
        <p:spPr>
          <a:xfrm>
            <a:off x="2457186" y="116115"/>
            <a:ext cx="28580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 Fig. S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FC893FA-4839-4D7B-BE4B-0AF352250AC4}"/>
              </a:ext>
            </a:extLst>
          </p:cNvPr>
          <p:cNvSpPr txBox="1"/>
          <p:nvPr/>
        </p:nvSpPr>
        <p:spPr>
          <a:xfrm>
            <a:off x="663547" y="6303327"/>
            <a:ext cx="697128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</a:pP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l Figure S7.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/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LT3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-ITD AML stain for myeloid and monocytic antigens.</a:t>
            </a:r>
            <a:endParaRPr lang="en-US" sz="12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</a:pP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AML blasts from the indicated mice stained with Mac-1, Gr-1, CD1/32, CD13, and F4/80.  </a:t>
            </a:r>
            <a:endParaRPr lang="en-US" sz="12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58489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601776C1-F353-9E1C-3E7C-4A075C1E79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94034" y="816453"/>
            <a:ext cx="2838954" cy="2560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547A9C3-1BCE-C4B0-30D9-A2E0F96307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9605" y="1556830"/>
            <a:ext cx="109157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1000" dirty="0">
                <a:latin typeface="Arial Narrow" panose="020B0606020202030204" pitchFamily="34" charset="0"/>
              </a:rPr>
              <a:t>NES=2.94</a:t>
            </a:r>
          </a:p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1000" dirty="0">
                <a:latin typeface="Arial Narrow" panose="020B0606020202030204" pitchFamily="34" charset="0"/>
              </a:rPr>
              <a:t>FDR q value= 0.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ADEFCE3-4806-6182-EC0E-971BE498DC84}"/>
              </a:ext>
            </a:extLst>
          </p:cNvPr>
          <p:cNvSpPr txBox="1"/>
          <p:nvPr/>
        </p:nvSpPr>
        <p:spPr>
          <a:xfrm>
            <a:off x="654683" y="700463"/>
            <a:ext cx="1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E5C5697-4EB8-B732-CD83-B88C6B013126}"/>
              </a:ext>
            </a:extLst>
          </p:cNvPr>
          <p:cNvSpPr txBox="1"/>
          <p:nvPr/>
        </p:nvSpPr>
        <p:spPr>
          <a:xfrm>
            <a:off x="1222021" y="2476582"/>
            <a:ext cx="16810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ouse NUP98-Nsd1/Flt3 AM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3A47418-64A1-9C1C-DE09-6627E118C371}"/>
              </a:ext>
            </a:extLst>
          </p:cNvPr>
          <p:cNvSpPr txBox="1"/>
          <p:nvPr/>
        </p:nvSpPr>
        <p:spPr>
          <a:xfrm>
            <a:off x="2709620" y="2482942"/>
            <a:ext cx="1109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accent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ouse Lin Neg BM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D7BB3F8-8FEF-96C3-3C34-FF17E032F92F}"/>
              </a:ext>
            </a:extLst>
          </p:cNvPr>
          <p:cNvSpPr txBox="1"/>
          <p:nvPr/>
        </p:nvSpPr>
        <p:spPr>
          <a:xfrm>
            <a:off x="654683" y="3622175"/>
            <a:ext cx="1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681C9F3-B8C1-F281-CA7E-5616D1343B55}"/>
              </a:ext>
            </a:extLst>
          </p:cNvPr>
          <p:cNvSpPr txBox="1"/>
          <p:nvPr/>
        </p:nvSpPr>
        <p:spPr>
          <a:xfrm>
            <a:off x="2457186" y="164886"/>
            <a:ext cx="28580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. S8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6952EECD-89F6-A772-DD75-E9C26CCE94A6}"/>
              </a:ext>
            </a:extLst>
          </p:cNvPr>
          <p:cNvGrpSpPr/>
          <p:nvPr/>
        </p:nvGrpSpPr>
        <p:grpSpPr>
          <a:xfrm>
            <a:off x="4075552" y="816453"/>
            <a:ext cx="3030148" cy="2560320"/>
            <a:chOff x="4070563" y="1101509"/>
            <a:chExt cx="2889856" cy="2560320"/>
          </a:xfrm>
        </p:grpSpPr>
        <p:pic>
          <p:nvPicPr>
            <p:cNvPr id="25" name="Picture 4">
              <a:extLst>
                <a:ext uri="{FF2B5EF4-FFF2-40B4-BE49-F238E27FC236}">
                  <a16:creationId xmlns:a16="http://schemas.microsoft.com/office/drawing/2014/main" id="{ADA8C30D-AAF9-3DC7-5FC7-8C7E060A62C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70563" y="1101509"/>
              <a:ext cx="2816012" cy="25603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DEDCAE0-C9DD-BE22-0B31-9D48C20A3AA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96017" y="1766067"/>
              <a:ext cx="1122519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lr>
                  <a:schemeClr val="accent1"/>
                </a:buClr>
                <a:buSzPct val="85000"/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lr>
                  <a:schemeClr val="accent1"/>
                </a:buClr>
                <a:buSzPct val="85000"/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lr>
                  <a:schemeClr val="accent1"/>
                </a:buClr>
                <a:buSzPct val="90000"/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lr>
                  <a:schemeClr val="accent1"/>
                </a:buClr>
                <a:buFont typeface="Arial" panose="020B0604020202020204" pitchFamily="34" charset="0"/>
                <a:buChar char="•"/>
                <a:defRPr sz="16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000" dirty="0">
                  <a:latin typeface="Arial Narrow" panose="020B0606020202030204" pitchFamily="34" charset="0"/>
                </a:rPr>
                <a:t>NES=3.79</a:t>
              </a:r>
            </a:p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US" altLang="en-US" sz="1000" dirty="0">
                  <a:latin typeface="Arial Narrow" panose="020B0606020202030204" pitchFamily="34" charset="0"/>
                </a:rPr>
                <a:t>FDR q value= 0.0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BB653E5-156B-542F-4CCF-96FF9099C241}"/>
                </a:ext>
              </a:extLst>
            </p:cNvPr>
            <p:cNvSpPr txBox="1"/>
            <p:nvPr/>
          </p:nvSpPr>
          <p:spPr>
            <a:xfrm>
              <a:off x="4326765" y="2789294"/>
              <a:ext cx="17287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Mouse NUP98-Nsd1/Flt3 AML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C567502-C721-1B5E-641F-FAAA96B42BF1}"/>
                </a:ext>
              </a:extLst>
            </p:cNvPr>
            <p:cNvSpPr txBox="1"/>
            <p:nvPr/>
          </p:nvSpPr>
          <p:spPr>
            <a:xfrm>
              <a:off x="5819169" y="2789293"/>
              <a:ext cx="11412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accent1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Mouse Lin Neg BM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55B7AB64-C1BA-59B7-A13B-B002E913E434}"/>
              </a:ext>
            </a:extLst>
          </p:cNvPr>
          <p:cNvGrpSpPr/>
          <p:nvPr/>
        </p:nvGrpSpPr>
        <p:grpSpPr>
          <a:xfrm>
            <a:off x="994034" y="3696602"/>
            <a:ext cx="2892166" cy="2589437"/>
            <a:chOff x="4047619" y="4052647"/>
            <a:chExt cx="3712447" cy="3649185"/>
          </a:xfrm>
        </p:grpSpPr>
        <p:pic>
          <p:nvPicPr>
            <p:cNvPr id="5" name="Picture 4" descr="Chart&#10;&#10;Description automatically generated">
              <a:extLst>
                <a:ext uri="{FF2B5EF4-FFF2-40B4-BE49-F238E27FC236}">
                  <a16:creationId xmlns:a16="http://schemas.microsoft.com/office/drawing/2014/main" id="{A43ADA57-53BE-231B-02E6-3C3C1E827A1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47619" y="4052647"/>
              <a:ext cx="3644144" cy="364918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253E3DD-41FC-CED4-890E-E296439E643E}"/>
                </a:ext>
              </a:extLst>
            </p:cNvPr>
            <p:cNvSpPr txBox="1"/>
            <p:nvPr/>
          </p:nvSpPr>
          <p:spPr>
            <a:xfrm>
              <a:off x="4590510" y="5086566"/>
              <a:ext cx="1347837" cy="5638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</a:rPr>
                <a:t>NES=1.730</a:t>
              </a:r>
            </a:p>
            <a:p>
              <a:r>
                <a:rPr lang="en-US" sz="1000" dirty="0">
                  <a:latin typeface="Arial Narrow" panose="020B0606020202030204" pitchFamily="34" charset="0"/>
                </a:rPr>
                <a:t>FDR q value=0.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19E892C-1D26-C5CD-1605-4439913441A4}"/>
                </a:ext>
              </a:extLst>
            </p:cNvPr>
            <p:cNvSpPr txBox="1"/>
            <p:nvPr/>
          </p:nvSpPr>
          <p:spPr>
            <a:xfrm>
              <a:off x="4375242" y="6310153"/>
              <a:ext cx="2076404" cy="3469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Mouse NUP98-Nsd1/Flt3 AM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B916242-6BCB-E180-11BF-446225E2E61E}"/>
                </a:ext>
              </a:extLst>
            </p:cNvPr>
            <p:cNvSpPr txBox="1"/>
            <p:nvPr/>
          </p:nvSpPr>
          <p:spPr>
            <a:xfrm>
              <a:off x="6335524" y="6310152"/>
              <a:ext cx="1424542" cy="3469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accent1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Mouse Lin Neg BM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D329F821-7C7C-5AE4-7950-B69C1313A57C}"/>
              </a:ext>
            </a:extLst>
          </p:cNvPr>
          <p:cNvGrpSpPr/>
          <p:nvPr/>
        </p:nvGrpSpPr>
        <p:grpSpPr>
          <a:xfrm>
            <a:off x="4070563" y="3727405"/>
            <a:ext cx="2962260" cy="2558633"/>
            <a:chOff x="2197280" y="1329266"/>
            <a:chExt cx="4762500" cy="4762500"/>
          </a:xfrm>
        </p:grpSpPr>
        <p:pic>
          <p:nvPicPr>
            <p:cNvPr id="29" name="Picture 28" descr="Chart&#10;&#10;Description automatically generated">
              <a:extLst>
                <a:ext uri="{FF2B5EF4-FFF2-40B4-BE49-F238E27FC236}">
                  <a16:creationId xmlns:a16="http://schemas.microsoft.com/office/drawing/2014/main" id="{05A93518-7D27-5F6C-98F8-378EFE259CC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97280" y="1329266"/>
              <a:ext cx="4762500" cy="4762500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572599E-82F6-BCC2-48A2-6AF5B8EB14A2}"/>
                </a:ext>
              </a:extLst>
            </p:cNvPr>
            <p:cNvSpPr txBox="1"/>
            <p:nvPr/>
          </p:nvSpPr>
          <p:spPr>
            <a:xfrm>
              <a:off x="2848222" y="2143011"/>
              <a:ext cx="1807508" cy="790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 Narrow" panose="020B0606020202030204" pitchFamily="34" charset="0"/>
                </a:rPr>
                <a:t>NES=0.978</a:t>
              </a:r>
            </a:p>
            <a:p>
              <a:r>
                <a:rPr lang="en-US" sz="1000" dirty="0">
                  <a:latin typeface="Arial Narrow" panose="020B0606020202030204" pitchFamily="34" charset="0"/>
                </a:rPr>
                <a:t>FDR q value=0.518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2157144-A00E-FF75-796E-CEAB87F70D4B}"/>
                </a:ext>
              </a:extLst>
            </p:cNvPr>
            <p:cNvSpPr txBox="1"/>
            <p:nvPr/>
          </p:nvSpPr>
          <p:spPr>
            <a:xfrm>
              <a:off x="2682184" y="4351754"/>
              <a:ext cx="2641912" cy="458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Mouse NUP98-Nsd1/Flt3 AML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AA5C0DD-AA7C-5B02-91C9-D8AD466D5ADB}"/>
                </a:ext>
              </a:extLst>
            </p:cNvPr>
            <p:cNvSpPr txBox="1"/>
            <p:nvPr/>
          </p:nvSpPr>
          <p:spPr>
            <a:xfrm>
              <a:off x="5121730" y="4351753"/>
              <a:ext cx="1754383" cy="4862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accent1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Mouse Lin Neg BM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3312211F-D073-1ECB-C66B-ECC4976C6D5B}"/>
              </a:ext>
            </a:extLst>
          </p:cNvPr>
          <p:cNvSpPr txBox="1"/>
          <p:nvPr/>
        </p:nvSpPr>
        <p:spPr>
          <a:xfrm>
            <a:off x="654683" y="6374573"/>
            <a:ext cx="6586917" cy="175432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igure S8. Gene expression profile of murine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/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LT3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-ITD AML is similar to that of human AML.  A.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Comparison of murin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/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FLT3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-ITD AML to human myelomonocytic leukemia and leukemia driven by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MLL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fusion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B.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Comparison to human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UP98::NSD1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AML: </a:t>
            </a:r>
          </a:p>
          <a:p>
            <a:r>
              <a:rPr lang="en-US" sz="1200" u="sng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Left Panel</a:t>
            </a:r>
            <a:r>
              <a:rPr lang="en-US" sz="12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: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P98::NSD1/FLT3-IT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L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se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359 upregulated genes in human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P98::NSD1/FLT3-ITD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ML compared to non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NUP98::NSD1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man AML. </a:t>
            </a:r>
            <a:r>
              <a:rPr lang="en-US" sz="1200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ight Panel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uman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T3-IT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ML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se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182 upregulated genes in human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T3-ITD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L compared to non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NUP98::NSD1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n-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T3-ITD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uman AML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 AML gene expression data was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tracted from GEO accession number: GSE17855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 Neg BM = Lineage Negative Bone Marrow; NES = Normalized Enrichment Score; FDR = False Discovery Rate.</a:t>
            </a:r>
          </a:p>
        </p:txBody>
      </p:sp>
    </p:spTree>
    <p:extLst>
      <p:ext uri="{BB962C8B-B14F-4D97-AF65-F5344CB8AC3E}">
        <p14:creationId xmlns:p14="http://schemas.microsoft.com/office/powerpoint/2010/main" val="1162451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Thema1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163F9B"/>
      </a:accent4>
      <a:accent5>
        <a:srgbClr val="F4D93F"/>
      </a:accent5>
      <a:accent6>
        <a:srgbClr val="0F2F6A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442</TotalTime>
  <Words>1062</Words>
  <Application>Microsoft Office PowerPoint</Application>
  <PresentationFormat>Custom</PresentationFormat>
  <Paragraphs>150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rial</vt:lpstr>
      <vt:lpstr>Arial Narrow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sukawa, Toshihiro (NIH/NCI) [F]</dc:creator>
  <cp:lastModifiedBy>Aplan, Peter (NIH/NCI) [E]</cp:lastModifiedBy>
  <cp:revision>204</cp:revision>
  <cp:lastPrinted>2023-02-15T20:34:56Z</cp:lastPrinted>
  <dcterms:created xsi:type="dcterms:W3CDTF">2020-09-05T22:59:21Z</dcterms:created>
  <dcterms:modified xsi:type="dcterms:W3CDTF">2023-04-13T18:02:25Z</dcterms:modified>
</cp:coreProperties>
</file>